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pdf" ContentType="application/pd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7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 xmlns:pic="http://schemas.openxmlformats.org/drawingml/2006/picture">
        <p:nvGrpSpPr>
          <p:cNvPr id="2" name=""/>
          <p:cNvGrpSpPr/>
          <p:nvPr/>
        </p:nvGrpSpPr>
        <p:grpSpPr>
          <a:xfrm rot="0">
            <a:off x="0" y="0"/>
            <a:ext cx="9144000" cy="6858000"/>
            <a:chOff x="0" y="0"/>
            <a:chExt cx="9144000" cy="6858000"/>
          </a:xfrm>
        </p:grpSpPr>
        <p:sp>
          <p:nvSpPr>
            <p:cNvPr id="3" name="rc3"/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" name="rc4"/>
            <p:cNvSpPr/>
            <p:nvPr/>
          </p:nvSpPr>
          <p:spPr>
            <a:xfrm>
              <a:off x="0" y="0"/>
              <a:ext cx="4572000" cy="342899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4782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5"/>
            <p:cNvSpPr/>
            <p:nvPr/>
          </p:nvSpPr>
          <p:spPr>
            <a:xfrm>
              <a:off x="575602" y="318231"/>
              <a:ext cx="2598057" cy="2666738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6" name="pl6"/>
            <p:cNvSpPr/>
            <p:nvPr/>
          </p:nvSpPr>
          <p:spPr>
            <a:xfrm>
              <a:off x="575602" y="2355082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" name="pl7"/>
            <p:cNvSpPr/>
            <p:nvPr/>
          </p:nvSpPr>
          <p:spPr>
            <a:xfrm>
              <a:off x="575602" y="1517114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8"/>
            <p:cNvSpPr/>
            <p:nvPr/>
          </p:nvSpPr>
          <p:spPr>
            <a:xfrm>
              <a:off x="575602" y="679146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9"/>
            <p:cNvSpPr/>
            <p:nvPr/>
          </p:nvSpPr>
          <p:spPr>
            <a:xfrm>
              <a:off x="693695" y="318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10"/>
            <p:cNvSpPr/>
            <p:nvPr/>
          </p:nvSpPr>
          <p:spPr>
            <a:xfrm>
              <a:off x="1218555" y="318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1"/>
            <p:cNvSpPr/>
            <p:nvPr/>
          </p:nvSpPr>
          <p:spPr>
            <a:xfrm>
              <a:off x="1743416" y="318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2"/>
            <p:cNvSpPr/>
            <p:nvPr/>
          </p:nvSpPr>
          <p:spPr>
            <a:xfrm>
              <a:off x="2268276" y="318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3"/>
            <p:cNvSpPr/>
            <p:nvPr/>
          </p:nvSpPr>
          <p:spPr>
            <a:xfrm>
              <a:off x="2793136" y="318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4"/>
            <p:cNvSpPr/>
            <p:nvPr/>
          </p:nvSpPr>
          <p:spPr>
            <a:xfrm>
              <a:off x="575602" y="2774066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5"/>
            <p:cNvSpPr/>
            <p:nvPr/>
          </p:nvSpPr>
          <p:spPr>
            <a:xfrm>
              <a:off x="575602" y="1936098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6"/>
            <p:cNvSpPr/>
            <p:nvPr/>
          </p:nvSpPr>
          <p:spPr>
            <a:xfrm>
              <a:off x="575602" y="1098130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7"/>
            <p:cNvSpPr/>
            <p:nvPr/>
          </p:nvSpPr>
          <p:spPr>
            <a:xfrm>
              <a:off x="956125" y="318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8"/>
            <p:cNvSpPr/>
            <p:nvPr/>
          </p:nvSpPr>
          <p:spPr>
            <a:xfrm>
              <a:off x="1480985" y="318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9"/>
            <p:cNvSpPr/>
            <p:nvPr/>
          </p:nvSpPr>
          <p:spPr>
            <a:xfrm>
              <a:off x="2005846" y="318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20"/>
            <p:cNvSpPr/>
            <p:nvPr/>
          </p:nvSpPr>
          <p:spPr>
            <a:xfrm>
              <a:off x="2530706" y="318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1"/>
            <p:cNvSpPr/>
            <p:nvPr/>
          </p:nvSpPr>
          <p:spPr>
            <a:xfrm>
              <a:off x="3055566" y="318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2"/>
            <p:cNvSpPr/>
            <p:nvPr/>
          </p:nvSpPr>
          <p:spPr>
            <a:xfrm>
              <a:off x="693695" y="460734"/>
              <a:ext cx="2361870" cy="1286315"/>
            </a:xfrm>
            <a:custGeom>
              <a:avLst/>
              <a:pathLst>
                <a:path w="2361870" h="1286315">
                  <a:moveTo>
                    <a:pt x="0" y="0"/>
                  </a:moveTo>
                  <a:lnTo>
                    <a:pt x="52486" y="64002"/>
                  </a:lnTo>
                  <a:lnTo>
                    <a:pt x="104972" y="95722"/>
                  </a:lnTo>
                  <a:lnTo>
                    <a:pt x="157458" y="123735"/>
                  </a:lnTo>
                  <a:lnTo>
                    <a:pt x="209944" y="160528"/>
                  </a:lnTo>
                  <a:lnTo>
                    <a:pt x="262430" y="196967"/>
                  </a:lnTo>
                  <a:lnTo>
                    <a:pt x="314916" y="225382"/>
                  </a:lnTo>
                  <a:lnTo>
                    <a:pt x="367402" y="255142"/>
                  </a:lnTo>
                  <a:lnTo>
                    <a:pt x="419888" y="283616"/>
                  </a:lnTo>
                  <a:lnTo>
                    <a:pt x="472374" y="315615"/>
                  </a:lnTo>
                  <a:lnTo>
                    <a:pt x="524860" y="346763"/>
                  </a:lnTo>
                  <a:lnTo>
                    <a:pt x="577346" y="366615"/>
                  </a:lnTo>
                  <a:lnTo>
                    <a:pt x="629832" y="391341"/>
                  </a:lnTo>
                  <a:lnTo>
                    <a:pt x="682318" y="425035"/>
                  </a:lnTo>
                  <a:lnTo>
                    <a:pt x="734804" y="447620"/>
                  </a:lnTo>
                  <a:lnTo>
                    <a:pt x="787290" y="472967"/>
                  </a:lnTo>
                  <a:lnTo>
                    <a:pt x="839776" y="502018"/>
                  </a:lnTo>
                  <a:lnTo>
                    <a:pt x="892262" y="541507"/>
                  </a:lnTo>
                  <a:lnTo>
                    <a:pt x="944748" y="583793"/>
                  </a:lnTo>
                  <a:lnTo>
                    <a:pt x="997234" y="606944"/>
                  </a:lnTo>
                  <a:lnTo>
                    <a:pt x="1049720" y="647361"/>
                  </a:lnTo>
                  <a:lnTo>
                    <a:pt x="1102206" y="672948"/>
                  </a:lnTo>
                  <a:lnTo>
                    <a:pt x="1154692" y="698031"/>
                  </a:lnTo>
                  <a:lnTo>
                    <a:pt x="1207178" y="739931"/>
                  </a:lnTo>
                  <a:lnTo>
                    <a:pt x="1259664" y="771185"/>
                  </a:lnTo>
                  <a:lnTo>
                    <a:pt x="1312150" y="798935"/>
                  </a:lnTo>
                  <a:lnTo>
                    <a:pt x="1364636" y="827170"/>
                  </a:lnTo>
                  <a:lnTo>
                    <a:pt x="1417122" y="858047"/>
                  </a:lnTo>
                  <a:lnTo>
                    <a:pt x="1469608" y="889123"/>
                  </a:lnTo>
                  <a:lnTo>
                    <a:pt x="1522094" y="911016"/>
                  </a:lnTo>
                  <a:lnTo>
                    <a:pt x="1574580" y="922761"/>
                  </a:lnTo>
                  <a:lnTo>
                    <a:pt x="1627066" y="942841"/>
                  </a:lnTo>
                  <a:lnTo>
                    <a:pt x="1679552" y="973258"/>
                  </a:lnTo>
                  <a:lnTo>
                    <a:pt x="1732038" y="1003239"/>
                  </a:lnTo>
                  <a:lnTo>
                    <a:pt x="1784524" y="1030166"/>
                  </a:lnTo>
                  <a:lnTo>
                    <a:pt x="1837010" y="1059164"/>
                  </a:lnTo>
                  <a:lnTo>
                    <a:pt x="1889496" y="1087803"/>
                  </a:lnTo>
                  <a:lnTo>
                    <a:pt x="1941982" y="1097722"/>
                  </a:lnTo>
                  <a:lnTo>
                    <a:pt x="1994468" y="1128505"/>
                  </a:lnTo>
                  <a:lnTo>
                    <a:pt x="2046954" y="1162586"/>
                  </a:lnTo>
                  <a:lnTo>
                    <a:pt x="2099440" y="1190392"/>
                  </a:lnTo>
                  <a:lnTo>
                    <a:pt x="2151926" y="1209295"/>
                  </a:lnTo>
                  <a:lnTo>
                    <a:pt x="2204412" y="1222691"/>
                  </a:lnTo>
                  <a:lnTo>
                    <a:pt x="2256898" y="1230852"/>
                  </a:lnTo>
                  <a:lnTo>
                    <a:pt x="2309384" y="1267522"/>
                  </a:lnTo>
                  <a:lnTo>
                    <a:pt x="2361870" y="1286315"/>
                  </a:lnTo>
                </a:path>
              </a:pathLst>
            </a:custGeom>
            <a:ln w="21681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3"/>
            <p:cNvSpPr/>
            <p:nvPr/>
          </p:nvSpPr>
          <p:spPr>
            <a:xfrm>
              <a:off x="693695" y="439677"/>
              <a:ext cx="2361870" cy="1228235"/>
            </a:xfrm>
            <a:custGeom>
              <a:avLst/>
              <a:pathLst>
                <a:path w="2361870" h="1228235">
                  <a:moveTo>
                    <a:pt x="0" y="0"/>
                  </a:moveTo>
                  <a:lnTo>
                    <a:pt x="52486" y="28653"/>
                  </a:lnTo>
                  <a:lnTo>
                    <a:pt x="104972" y="57922"/>
                  </a:lnTo>
                  <a:lnTo>
                    <a:pt x="157458" y="87828"/>
                  </a:lnTo>
                  <a:lnTo>
                    <a:pt x="209944" y="118392"/>
                  </a:lnTo>
                  <a:lnTo>
                    <a:pt x="262430" y="149634"/>
                  </a:lnTo>
                  <a:lnTo>
                    <a:pt x="314916" y="181578"/>
                  </a:lnTo>
                  <a:lnTo>
                    <a:pt x="367402" y="214249"/>
                  </a:lnTo>
                  <a:lnTo>
                    <a:pt x="419888" y="247670"/>
                  </a:lnTo>
                  <a:lnTo>
                    <a:pt x="472374" y="281153"/>
                  </a:lnTo>
                  <a:lnTo>
                    <a:pt x="524860" y="318941"/>
                  </a:lnTo>
                  <a:lnTo>
                    <a:pt x="577346" y="360874"/>
                  </a:lnTo>
                  <a:lnTo>
                    <a:pt x="629832" y="406783"/>
                  </a:lnTo>
                  <a:lnTo>
                    <a:pt x="682318" y="449202"/>
                  </a:lnTo>
                  <a:lnTo>
                    <a:pt x="734804" y="497172"/>
                  </a:lnTo>
                  <a:lnTo>
                    <a:pt x="787290" y="541286"/>
                  </a:lnTo>
                  <a:lnTo>
                    <a:pt x="839776" y="579950"/>
                  </a:lnTo>
                  <a:lnTo>
                    <a:pt x="892262" y="620507"/>
                  </a:lnTo>
                  <a:lnTo>
                    <a:pt x="944748" y="663888"/>
                  </a:lnTo>
                  <a:lnTo>
                    <a:pt x="997234" y="721021"/>
                  </a:lnTo>
                  <a:lnTo>
                    <a:pt x="1049720" y="741692"/>
                  </a:lnTo>
                  <a:lnTo>
                    <a:pt x="1102206" y="782290"/>
                  </a:lnTo>
                  <a:lnTo>
                    <a:pt x="1154692" y="814967"/>
                  </a:lnTo>
                  <a:lnTo>
                    <a:pt x="1207178" y="850871"/>
                  </a:lnTo>
                  <a:lnTo>
                    <a:pt x="1259664" y="846052"/>
                  </a:lnTo>
                  <a:lnTo>
                    <a:pt x="1312150" y="875889"/>
                  </a:lnTo>
                  <a:lnTo>
                    <a:pt x="1364636" y="897417"/>
                  </a:lnTo>
                  <a:lnTo>
                    <a:pt x="1417122" y="931861"/>
                  </a:lnTo>
                  <a:lnTo>
                    <a:pt x="1469608" y="941546"/>
                  </a:lnTo>
                  <a:lnTo>
                    <a:pt x="1522094" y="945529"/>
                  </a:lnTo>
                  <a:lnTo>
                    <a:pt x="1574580" y="924879"/>
                  </a:lnTo>
                  <a:lnTo>
                    <a:pt x="1627066" y="975988"/>
                  </a:lnTo>
                  <a:lnTo>
                    <a:pt x="1679552" y="983987"/>
                  </a:lnTo>
                  <a:lnTo>
                    <a:pt x="1732038" y="1005859"/>
                  </a:lnTo>
                  <a:lnTo>
                    <a:pt x="1784524" y="1051656"/>
                  </a:lnTo>
                  <a:lnTo>
                    <a:pt x="1837010" y="1081686"/>
                  </a:lnTo>
                  <a:lnTo>
                    <a:pt x="1889496" y="1105581"/>
                  </a:lnTo>
                  <a:lnTo>
                    <a:pt x="1941982" y="1109985"/>
                  </a:lnTo>
                  <a:lnTo>
                    <a:pt x="1994468" y="1142851"/>
                  </a:lnTo>
                  <a:lnTo>
                    <a:pt x="2046954" y="1139050"/>
                  </a:lnTo>
                  <a:lnTo>
                    <a:pt x="2099440" y="1193064"/>
                  </a:lnTo>
                  <a:lnTo>
                    <a:pt x="2151926" y="1226444"/>
                  </a:lnTo>
                  <a:lnTo>
                    <a:pt x="2204412" y="1196630"/>
                  </a:lnTo>
                  <a:lnTo>
                    <a:pt x="2256898" y="1201856"/>
                  </a:lnTo>
                  <a:lnTo>
                    <a:pt x="2309384" y="1224615"/>
                  </a:lnTo>
                  <a:lnTo>
                    <a:pt x="2361870" y="1228235"/>
                  </a:lnTo>
                </a:path>
              </a:pathLst>
            </a:custGeom>
            <a:ln w="21681" cap="flat">
              <a:solidFill>
                <a:srgbClr val="A3A5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4"/>
            <p:cNvSpPr/>
            <p:nvPr/>
          </p:nvSpPr>
          <p:spPr>
            <a:xfrm>
              <a:off x="693695" y="439446"/>
              <a:ext cx="2361870" cy="1193295"/>
            </a:xfrm>
            <a:custGeom>
              <a:avLst/>
              <a:pathLst>
                <a:path w="2361870" h="1193295">
                  <a:moveTo>
                    <a:pt x="0" y="0"/>
                  </a:moveTo>
                  <a:lnTo>
                    <a:pt x="52486" y="28604"/>
                  </a:lnTo>
                  <a:lnTo>
                    <a:pt x="104972" y="57823"/>
                  </a:lnTo>
                  <a:lnTo>
                    <a:pt x="157458" y="87677"/>
                  </a:lnTo>
                  <a:lnTo>
                    <a:pt x="209944" y="118188"/>
                  </a:lnTo>
                  <a:lnTo>
                    <a:pt x="262430" y="149377"/>
                  </a:lnTo>
                  <a:lnTo>
                    <a:pt x="314916" y="181266"/>
                  </a:lnTo>
                  <a:lnTo>
                    <a:pt x="367402" y="217678"/>
                  </a:lnTo>
                  <a:lnTo>
                    <a:pt x="419888" y="249013"/>
                  </a:lnTo>
                  <a:lnTo>
                    <a:pt x="472374" y="286599"/>
                  </a:lnTo>
                  <a:lnTo>
                    <a:pt x="524860" y="325638"/>
                  </a:lnTo>
                  <a:lnTo>
                    <a:pt x="577346" y="358593"/>
                  </a:lnTo>
                  <a:lnTo>
                    <a:pt x="629832" y="402618"/>
                  </a:lnTo>
                  <a:lnTo>
                    <a:pt x="682318" y="434314"/>
                  </a:lnTo>
                  <a:lnTo>
                    <a:pt x="734804" y="481609"/>
                  </a:lnTo>
                  <a:lnTo>
                    <a:pt x="787290" y="511842"/>
                  </a:lnTo>
                  <a:lnTo>
                    <a:pt x="839776" y="549128"/>
                  </a:lnTo>
                  <a:lnTo>
                    <a:pt x="892262" y="578240"/>
                  </a:lnTo>
                  <a:lnTo>
                    <a:pt x="944748" y="639967"/>
                  </a:lnTo>
                  <a:lnTo>
                    <a:pt x="997234" y="675437"/>
                  </a:lnTo>
                  <a:lnTo>
                    <a:pt x="1049720" y="712614"/>
                  </a:lnTo>
                  <a:lnTo>
                    <a:pt x="1102206" y="760421"/>
                  </a:lnTo>
                  <a:lnTo>
                    <a:pt x="1154692" y="766114"/>
                  </a:lnTo>
                  <a:lnTo>
                    <a:pt x="1207178" y="781980"/>
                  </a:lnTo>
                  <a:lnTo>
                    <a:pt x="1259664" y="775692"/>
                  </a:lnTo>
                  <a:lnTo>
                    <a:pt x="1312150" y="811430"/>
                  </a:lnTo>
                  <a:lnTo>
                    <a:pt x="1364636" y="816281"/>
                  </a:lnTo>
                  <a:lnTo>
                    <a:pt x="1417122" y="833301"/>
                  </a:lnTo>
                  <a:lnTo>
                    <a:pt x="1469608" y="858179"/>
                  </a:lnTo>
                  <a:lnTo>
                    <a:pt x="1522094" y="862094"/>
                  </a:lnTo>
                  <a:lnTo>
                    <a:pt x="1574580" y="895687"/>
                  </a:lnTo>
                  <a:lnTo>
                    <a:pt x="1627066" y="912745"/>
                  </a:lnTo>
                  <a:lnTo>
                    <a:pt x="1679552" y="954699"/>
                  </a:lnTo>
                  <a:lnTo>
                    <a:pt x="1732038" y="984959"/>
                  </a:lnTo>
                  <a:lnTo>
                    <a:pt x="1784524" y="1001724"/>
                  </a:lnTo>
                  <a:lnTo>
                    <a:pt x="1837010" y="1040884"/>
                  </a:lnTo>
                  <a:lnTo>
                    <a:pt x="1889496" y="1058718"/>
                  </a:lnTo>
                  <a:lnTo>
                    <a:pt x="1941982" y="1070648"/>
                  </a:lnTo>
                  <a:lnTo>
                    <a:pt x="1994468" y="1110765"/>
                  </a:lnTo>
                  <a:lnTo>
                    <a:pt x="2046954" y="1140223"/>
                  </a:lnTo>
                  <a:lnTo>
                    <a:pt x="2099440" y="1142935"/>
                  </a:lnTo>
                  <a:lnTo>
                    <a:pt x="2151926" y="1165451"/>
                  </a:lnTo>
                  <a:lnTo>
                    <a:pt x="2204412" y="1164179"/>
                  </a:lnTo>
                  <a:lnTo>
                    <a:pt x="2256898" y="1179767"/>
                  </a:lnTo>
                  <a:lnTo>
                    <a:pt x="2309384" y="1180881"/>
                  </a:lnTo>
                  <a:lnTo>
                    <a:pt x="2361870" y="1193295"/>
                  </a:lnTo>
                </a:path>
              </a:pathLst>
            </a:custGeom>
            <a:ln w="21681" cap="flat">
              <a:solidFill>
                <a:srgbClr val="00BF7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5"/>
            <p:cNvSpPr/>
            <p:nvPr/>
          </p:nvSpPr>
          <p:spPr>
            <a:xfrm>
              <a:off x="693695" y="442454"/>
              <a:ext cx="2361870" cy="1040807"/>
            </a:xfrm>
            <a:custGeom>
              <a:avLst/>
              <a:pathLst>
                <a:path w="2361870" h="1040807">
                  <a:moveTo>
                    <a:pt x="0" y="0"/>
                  </a:moveTo>
                  <a:lnTo>
                    <a:pt x="52486" y="28028"/>
                  </a:lnTo>
                  <a:lnTo>
                    <a:pt x="104972" y="55240"/>
                  </a:lnTo>
                  <a:lnTo>
                    <a:pt x="157458" y="88492"/>
                  </a:lnTo>
                  <a:lnTo>
                    <a:pt x="209944" y="119238"/>
                  </a:lnTo>
                  <a:lnTo>
                    <a:pt x="262430" y="144903"/>
                  </a:lnTo>
                  <a:lnTo>
                    <a:pt x="314916" y="176282"/>
                  </a:lnTo>
                  <a:lnTo>
                    <a:pt x="367402" y="227859"/>
                  </a:lnTo>
                  <a:lnTo>
                    <a:pt x="419888" y="251412"/>
                  </a:lnTo>
                  <a:lnTo>
                    <a:pt x="472374" y="280319"/>
                  </a:lnTo>
                  <a:lnTo>
                    <a:pt x="524860" y="303751"/>
                  </a:lnTo>
                  <a:lnTo>
                    <a:pt x="577346" y="341139"/>
                  </a:lnTo>
                  <a:lnTo>
                    <a:pt x="629832" y="361313"/>
                  </a:lnTo>
                  <a:lnTo>
                    <a:pt x="682318" y="405248"/>
                  </a:lnTo>
                  <a:lnTo>
                    <a:pt x="734804" y="428069"/>
                  </a:lnTo>
                  <a:lnTo>
                    <a:pt x="787290" y="454977"/>
                  </a:lnTo>
                  <a:lnTo>
                    <a:pt x="839776" y="482733"/>
                  </a:lnTo>
                  <a:lnTo>
                    <a:pt x="892262" y="495757"/>
                  </a:lnTo>
                  <a:lnTo>
                    <a:pt x="944748" y="530930"/>
                  </a:lnTo>
                  <a:lnTo>
                    <a:pt x="997234" y="546551"/>
                  </a:lnTo>
                  <a:lnTo>
                    <a:pt x="1049720" y="539609"/>
                  </a:lnTo>
                  <a:lnTo>
                    <a:pt x="1102206" y="565631"/>
                  </a:lnTo>
                  <a:lnTo>
                    <a:pt x="1154692" y="591222"/>
                  </a:lnTo>
                  <a:lnTo>
                    <a:pt x="1207178" y="617280"/>
                  </a:lnTo>
                  <a:lnTo>
                    <a:pt x="1259664" y="641780"/>
                  </a:lnTo>
                  <a:lnTo>
                    <a:pt x="1312150" y="671503"/>
                  </a:lnTo>
                  <a:lnTo>
                    <a:pt x="1364636" y="711390"/>
                  </a:lnTo>
                  <a:lnTo>
                    <a:pt x="1417122" y="733571"/>
                  </a:lnTo>
                  <a:lnTo>
                    <a:pt x="1469608" y="743290"/>
                  </a:lnTo>
                  <a:lnTo>
                    <a:pt x="1522094" y="762230"/>
                  </a:lnTo>
                  <a:lnTo>
                    <a:pt x="1574580" y="786149"/>
                  </a:lnTo>
                  <a:lnTo>
                    <a:pt x="1627066" y="799825"/>
                  </a:lnTo>
                  <a:lnTo>
                    <a:pt x="1679552" y="786928"/>
                  </a:lnTo>
                  <a:lnTo>
                    <a:pt x="1732038" y="805383"/>
                  </a:lnTo>
                  <a:lnTo>
                    <a:pt x="1784524" y="820551"/>
                  </a:lnTo>
                  <a:lnTo>
                    <a:pt x="1837010" y="853224"/>
                  </a:lnTo>
                  <a:lnTo>
                    <a:pt x="1889496" y="867556"/>
                  </a:lnTo>
                  <a:lnTo>
                    <a:pt x="1941982" y="887537"/>
                  </a:lnTo>
                  <a:lnTo>
                    <a:pt x="1994468" y="911304"/>
                  </a:lnTo>
                  <a:lnTo>
                    <a:pt x="2046954" y="938432"/>
                  </a:lnTo>
                  <a:lnTo>
                    <a:pt x="2099440" y="971263"/>
                  </a:lnTo>
                  <a:lnTo>
                    <a:pt x="2151926" y="993748"/>
                  </a:lnTo>
                  <a:lnTo>
                    <a:pt x="2204412" y="1025212"/>
                  </a:lnTo>
                  <a:lnTo>
                    <a:pt x="2256898" y="1031337"/>
                  </a:lnTo>
                  <a:lnTo>
                    <a:pt x="2309384" y="1030376"/>
                  </a:lnTo>
                  <a:lnTo>
                    <a:pt x="2361870" y="1040807"/>
                  </a:lnTo>
                </a:path>
              </a:pathLst>
            </a:custGeom>
            <a:ln w="21681" cap="flat">
              <a:solidFill>
                <a:srgbClr val="00B0F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6"/>
            <p:cNvSpPr/>
            <p:nvPr/>
          </p:nvSpPr>
          <p:spPr>
            <a:xfrm>
              <a:off x="693695" y="1191706"/>
              <a:ext cx="2361870" cy="739995"/>
            </a:xfrm>
            <a:custGeom>
              <a:avLst/>
              <a:pathLst>
                <a:path w="2361870" h="739995">
                  <a:moveTo>
                    <a:pt x="0" y="0"/>
                  </a:moveTo>
                  <a:lnTo>
                    <a:pt x="52486" y="66400"/>
                  </a:lnTo>
                  <a:lnTo>
                    <a:pt x="104972" y="116973"/>
                  </a:lnTo>
                  <a:lnTo>
                    <a:pt x="157458" y="204008"/>
                  </a:lnTo>
                  <a:lnTo>
                    <a:pt x="209944" y="260587"/>
                  </a:lnTo>
                  <a:lnTo>
                    <a:pt x="262430" y="334054"/>
                  </a:lnTo>
                  <a:lnTo>
                    <a:pt x="314916" y="371630"/>
                  </a:lnTo>
                  <a:lnTo>
                    <a:pt x="367402" y="424648"/>
                  </a:lnTo>
                  <a:lnTo>
                    <a:pt x="419888" y="451091"/>
                  </a:lnTo>
                  <a:lnTo>
                    <a:pt x="472374" y="466392"/>
                  </a:lnTo>
                  <a:lnTo>
                    <a:pt x="524860" y="475431"/>
                  </a:lnTo>
                  <a:lnTo>
                    <a:pt x="577346" y="496724"/>
                  </a:lnTo>
                  <a:lnTo>
                    <a:pt x="629832" y="515987"/>
                  </a:lnTo>
                  <a:lnTo>
                    <a:pt x="682318" y="543012"/>
                  </a:lnTo>
                  <a:lnTo>
                    <a:pt x="734804" y="551436"/>
                  </a:lnTo>
                  <a:lnTo>
                    <a:pt x="787290" y="581722"/>
                  </a:lnTo>
                  <a:lnTo>
                    <a:pt x="839776" y="589903"/>
                  </a:lnTo>
                  <a:lnTo>
                    <a:pt x="892262" y="602352"/>
                  </a:lnTo>
                  <a:lnTo>
                    <a:pt x="944748" y="619064"/>
                  </a:lnTo>
                  <a:lnTo>
                    <a:pt x="997234" y="635637"/>
                  </a:lnTo>
                  <a:lnTo>
                    <a:pt x="1049720" y="640342"/>
                  </a:lnTo>
                  <a:lnTo>
                    <a:pt x="1102206" y="649452"/>
                  </a:lnTo>
                  <a:lnTo>
                    <a:pt x="1154692" y="646525"/>
                  </a:lnTo>
                  <a:lnTo>
                    <a:pt x="1207178" y="651089"/>
                  </a:lnTo>
                  <a:lnTo>
                    <a:pt x="1259664" y="651261"/>
                  </a:lnTo>
                  <a:lnTo>
                    <a:pt x="1312150" y="655834"/>
                  </a:lnTo>
                  <a:lnTo>
                    <a:pt x="1364636" y="660413"/>
                  </a:lnTo>
                  <a:lnTo>
                    <a:pt x="1417122" y="660600"/>
                  </a:lnTo>
                  <a:lnTo>
                    <a:pt x="1469608" y="678379"/>
                  </a:lnTo>
                  <a:lnTo>
                    <a:pt x="1522094" y="682974"/>
                  </a:lnTo>
                  <a:lnTo>
                    <a:pt x="1574580" y="683179"/>
                  </a:lnTo>
                  <a:lnTo>
                    <a:pt x="1627066" y="687787"/>
                  </a:lnTo>
                  <a:lnTo>
                    <a:pt x="1679552" y="685423"/>
                  </a:lnTo>
                  <a:lnTo>
                    <a:pt x="1732038" y="685536"/>
                  </a:lnTo>
                  <a:lnTo>
                    <a:pt x="1784524" y="685652"/>
                  </a:lnTo>
                  <a:lnTo>
                    <a:pt x="1837010" y="685772"/>
                  </a:lnTo>
                  <a:lnTo>
                    <a:pt x="1889496" y="690293"/>
                  </a:lnTo>
                  <a:lnTo>
                    <a:pt x="1941982" y="699214"/>
                  </a:lnTo>
                  <a:lnTo>
                    <a:pt x="1994468" y="699347"/>
                  </a:lnTo>
                  <a:lnTo>
                    <a:pt x="2046954" y="708278"/>
                  </a:lnTo>
                  <a:lnTo>
                    <a:pt x="2099440" y="708421"/>
                  </a:lnTo>
                  <a:lnTo>
                    <a:pt x="2151926" y="717362"/>
                  </a:lnTo>
                  <a:lnTo>
                    <a:pt x="2204412" y="730705"/>
                  </a:lnTo>
                  <a:lnTo>
                    <a:pt x="2256898" y="735261"/>
                  </a:lnTo>
                  <a:lnTo>
                    <a:pt x="2309384" y="739823"/>
                  </a:lnTo>
                  <a:lnTo>
                    <a:pt x="2361870" y="739995"/>
                  </a:lnTo>
                </a:path>
              </a:pathLst>
            </a:custGeom>
            <a:ln w="21681" cap="flat">
              <a:solidFill>
                <a:srgbClr val="E76BF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7"/>
            <p:cNvSpPr/>
            <p:nvPr/>
          </p:nvSpPr>
          <p:spPr>
            <a:xfrm>
              <a:off x="693695" y="439677"/>
              <a:ext cx="2361870" cy="2424076"/>
            </a:xfrm>
            <a:custGeom>
              <a:avLst/>
              <a:pathLst>
                <a:path w="2361870" h="2424076">
                  <a:moveTo>
                    <a:pt x="0" y="0"/>
                  </a:moveTo>
                  <a:lnTo>
                    <a:pt x="52486" y="28653"/>
                  </a:lnTo>
                  <a:lnTo>
                    <a:pt x="104972" y="57922"/>
                  </a:lnTo>
                  <a:lnTo>
                    <a:pt x="157458" y="87828"/>
                  </a:lnTo>
                  <a:lnTo>
                    <a:pt x="209944" y="118392"/>
                  </a:lnTo>
                  <a:lnTo>
                    <a:pt x="262430" y="149634"/>
                  </a:lnTo>
                  <a:lnTo>
                    <a:pt x="314916" y="181578"/>
                  </a:lnTo>
                  <a:lnTo>
                    <a:pt x="367402" y="214249"/>
                  </a:lnTo>
                  <a:lnTo>
                    <a:pt x="419888" y="247670"/>
                  </a:lnTo>
                  <a:lnTo>
                    <a:pt x="472374" y="281869"/>
                  </a:lnTo>
                  <a:lnTo>
                    <a:pt x="524860" y="316872"/>
                  </a:lnTo>
                  <a:lnTo>
                    <a:pt x="577346" y="352709"/>
                  </a:lnTo>
                  <a:lnTo>
                    <a:pt x="629832" y="389409"/>
                  </a:lnTo>
                  <a:lnTo>
                    <a:pt x="682318" y="427005"/>
                  </a:lnTo>
                  <a:lnTo>
                    <a:pt x="734804" y="465529"/>
                  </a:lnTo>
                  <a:lnTo>
                    <a:pt x="787290" y="505015"/>
                  </a:lnTo>
                  <a:lnTo>
                    <a:pt x="839776" y="545502"/>
                  </a:lnTo>
                  <a:lnTo>
                    <a:pt x="892262" y="587027"/>
                  </a:lnTo>
                  <a:lnTo>
                    <a:pt x="944748" y="629630"/>
                  </a:lnTo>
                  <a:lnTo>
                    <a:pt x="997234" y="673354"/>
                  </a:lnTo>
                  <a:lnTo>
                    <a:pt x="1049720" y="718244"/>
                  </a:lnTo>
                  <a:lnTo>
                    <a:pt x="1102206" y="764348"/>
                  </a:lnTo>
                  <a:lnTo>
                    <a:pt x="1154692" y="811715"/>
                  </a:lnTo>
                  <a:lnTo>
                    <a:pt x="1207178" y="860397"/>
                  </a:lnTo>
                  <a:lnTo>
                    <a:pt x="1259664" y="910451"/>
                  </a:lnTo>
                  <a:lnTo>
                    <a:pt x="1312150" y="961935"/>
                  </a:lnTo>
                  <a:lnTo>
                    <a:pt x="1364636" y="1014911"/>
                  </a:lnTo>
                  <a:lnTo>
                    <a:pt x="1417122" y="1069445"/>
                  </a:lnTo>
                  <a:lnTo>
                    <a:pt x="1469608" y="1125607"/>
                  </a:lnTo>
                  <a:lnTo>
                    <a:pt x="1522094" y="1183471"/>
                  </a:lnTo>
                  <a:lnTo>
                    <a:pt x="1574580" y="1243116"/>
                  </a:lnTo>
                  <a:lnTo>
                    <a:pt x="1627066" y="1304624"/>
                  </a:lnTo>
                  <a:lnTo>
                    <a:pt x="1679552" y="1368085"/>
                  </a:lnTo>
                  <a:lnTo>
                    <a:pt x="1732038" y="1433593"/>
                  </a:lnTo>
                  <a:lnTo>
                    <a:pt x="1784524" y="1501249"/>
                  </a:lnTo>
                  <a:lnTo>
                    <a:pt x="1837010" y="1571160"/>
                  </a:lnTo>
                  <a:lnTo>
                    <a:pt x="1889496" y="1643441"/>
                  </a:lnTo>
                  <a:lnTo>
                    <a:pt x="1941982" y="1718215"/>
                  </a:lnTo>
                  <a:lnTo>
                    <a:pt x="1994468" y="1795612"/>
                  </a:lnTo>
                  <a:lnTo>
                    <a:pt x="2046954" y="1875773"/>
                  </a:lnTo>
                  <a:lnTo>
                    <a:pt x="2099440" y="1958849"/>
                  </a:lnTo>
                  <a:lnTo>
                    <a:pt x="2151926" y="2045002"/>
                  </a:lnTo>
                  <a:lnTo>
                    <a:pt x="2204412" y="2134407"/>
                  </a:lnTo>
                  <a:lnTo>
                    <a:pt x="2256898" y="2227249"/>
                  </a:lnTo>
                  <a:lnTo>
                    <a:pt x="2309384" y="2323733"/>
                  </a:lnTo>
                  <a:lnTo>
                    <a:pt x="2361870" y="2424076"/>
                  </a:lnTo>
                </a:path>
              </a:pathLst>
            </a:custGeom>
            <a:ln w="21681" cap="flat">
              <a:solidFill>
                <a:srgbClr val="00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/>
          </p:txBody>
        </p:sp>
        <p:sp>
          <p:nvSpPr>
            <p:cNvPr id="28" name="pl28"/>
            <p:cNvSpPr/>
            <p:nvPr/>
          </p:nvSpPr>
          <p:spPr>
            <a:xfrm>
              <a:off x="693695" y="1936098"/>
              <a:ext cx="2361870" cy="0"/>
            </a:xfrm>
            <a:custGeom>
              <a:avLst/>
              <a:pathLst>
                <a:path w="2361870" h="0">
                  <a:moveTo>
                    <a:pt x="0" y="0"/>
                  </a:moveTo>
                  <a:lnTo>
                    <a:pt x="52486" y="0"/>
                  </a:lnTo>
                  <a:lnTo>
                    <a:pt x="104972" y="0"/>
                  </a:lnTo>
                  <a:lnTo>
                    <a:pt x="157458" y="0"/>
                  </a:lnTo>
                  <a:lnTo>
                    <a:pt x="209944" y="0"/>
                  </a:lnTo>
                  <a:lnTo>
                    <a:pt x="262430" y="0"/>
                  </a:lnTo>
                  <a:lnTo>
                    <a:pt x="314916" y="0"/>
                  </a:lnTo>
                  <a:lnTo>
                    <a:pt x="367402" y="0"/>
                  </a:lnTo>
                  <a:lnTo>
                    <a:pt x="419888" y="0"/>
                  </a:lnTo>
                  <a:lnTo>
                    <a:pt x="472374" y="0"/>
                  </a:lnTo>
                  <a:lnTo>
                    <a:pt x="524860" y="0"/>
                  </a:lnTo>
                  <a:lnTo>
                    <a:pt x="577346" y="0"/>
                  </a:lnTo>
                  <a:lnTo>
                    <a:pt x="629832" y="0"/>
                  </a:lnTo>
                  <a:lnTo>
                    <a:pt x="682318" y="0"/>
                  </a:lnTo>
                  <a:lnTo>
                    <a:pt x="734804" y="0"/>
                  </a:lnTo>
                  <a:lnTo>
                    <a:pt x="787290" y="0"/>
                  </a:lnTo>
                  <a:lnTo>
                    <a:pt x="839776" y="0"/>
                  </a:lnTo>
                  <a:lnTo>
                    <a:pt x="892262" y="0"/>
                  </a:lnTo>
                  <a:lnTo>
                    <a:pt x="944748" y="0"/>
                  </a:lnTo>
                  <a:lnTo>
                    <a:pt x="997234" y="0"/>
                  </a:lnTo>
                  <a:lnTo>
                    <a:pt x="1049720" y="0"/>
                  </a:lnTo>
                  <a:lnTo>
                    <a:pt x="1102206" y="0"/>
                  </a:lnTo>
                  <a:lnTo>
                    <a:pt x="1154692" y="0"/>
                  </a:lnTo>
                  <a:lnTo>
                    <a:pt x="1207178" y="0"/>
                  </a:lnTo>
                  <a:lnTo>
                    <a:pt x="1259664" y="0"/>
                  </a:lnTo>
                  <a:lnTo>
                    <a:pt x="1312150" y="0"/>
                  </a:lnTo>
                  <a:lnTo>
                    <a:pt x="1364636" y="0"/>
                  </a:lnTo>
                  <a:lnTo>
                    <a:pt x="1417122" y="0"/>
                  </a:lnTo>
                  <a:lnTo>
                    <a:pt x="1469608" y="0"/>
                  </a:lnTo>
                  <a:lnTo>
                    <a:pt x="1522094" y="0"/>
                  </a:lnTo>
                  <a:lnTo>
                    <a:pt x="1574580" y="0"/>
                  </a:lnTo>
                  <a:lnTo>
                    <a:pt x="1627066" y="0"/>
                  </a:lnTo>
                  <a:lnTo>
                    <a:pt x="1679552" y="0"/>
                  </a:lnTo>
                  <a:lnTo>
                    <a:pt x="1732038" y="0"/>
                  </a:lnTo>
                  <a:lnTo>
                    <a:pt x="1784524" y="0"/>
                  </a:lnTo>
                  <a:lnTo>
                    <a:pt x="1837010" y="0"/>
                  </a:lnTo>
                  <a:lnTo>
                    <a:pt x="1889496" y="0"/>
                  </a:lnTo>
                  <a:lnTo>
                    <a:pt x="1941982" y="0"/>
                  </a:lnTo>
                  <a:lnTo>
                    <a:pt x="1994468" y="0"/>
                  </a:lnTo>
                  <a:lnTo>
                    <a:pt x="2046954" y="0"/>
                  </a:lnTo>
                  <a:lnTo>
                    <a:pt x="2099440" y="0"/>
                  </a:lnTo>
                  <a:lnTo>
                    <a:pt x="2151926" y="0"/>
                  </a:lnTo>
                  <a:lnTo>
                    <a:pt x="2204412" y="0"/>
                  </a:lnTo>
                  <a:lnTo>
                    <a:pt x="2256898" y="0"/>
                  </a:lnTo>
                  <a:lnTo>
                    <a:pt x="2309384" y="0"/>
                  </a:lnTo>
                  <a:lnTo>
                    <a:pt x="2361870" y="0"/>
                  </a:lnTo>
                </a:path>
              </a:pathLst>
            </a:custGeom>
            <a:ln w="21681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29" name="tx29"/>
            <p:cNvSpPr/>
            <p:nvPr/>
          </p:nvSpPr>
          <p:spPr>
            <a:xfrm>
              <a:off x="154292" y="327283"/>
              <a:ext cx="337047" cy="18105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991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(A)</a:t>
              </a:r>
            </a:p>
          </p:txBody>
        </p:sp>
        <p:sp>
          <p:nvSpPr>
            <p:cNvPr id="30" name="rc30"/>
            <p:cNvSpPr/>
            <p:nvPr/>
          </p:nvSpPr>
          <p:spPr>
            <a:xfrm>
              <a:off x="575602" y="318231"/>
              <a:ext cx="2598057" cy="2666738"/>
            </a:xfrm>
            <a:prstGeom prst="rect">
              <a:avLst/>
            </a:prstGeom>
            <a:noFill/>
            <a:ln w="14782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tx31"/>
            <p:cNvSpPr/>
            <p:nvPr/>
          </p:nvSpPr>
          <p:spPr>
            <a:xfrm>
              <a:off x="297332" y="2730449"/>
              <a:ext cx="2099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2</a:t>
              </a:r>
            </a:p>
          </p:txBody>
        </p:sp>
        <p:sp>
          <p:nvSpPr>
            <p:cNvPr id="32" name="tx32"/>
            <p:cNvSpPr/>
            <p:nvPr/>
          </p:nvSpPr>
          <p:spPr>
            <a:xfrm>
              <a:off x="337931" y="1892481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</a:t>
              </a:r>
            </a:p>
          </p:txBody>
        </p:sp>
        <p:sp>
          <p:nvSpPr>
            <p:cNvPr id="33" name="tx33"/>
            <p:cNvSpPr/>
            <p:nvPr/>
          </p:nvSpPr>
          <p:spPr>
            <a:xfrm>
              <a:off x="337931" y="1054513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</a:t>
              </a:r>
            </a:p>
          </p:txBody>
        </p:sp>
        <p:sp>
          <p:nvSpPr>
            <p:cNvPr id="34" name="pl34"/>
            <p:cNvSpPr/>
            <p:nvPr/>
          </p:nvSpPr>
          <p:spPr>
            <a:xfrm>
              <a:off x="537644" y="2774066"/>
              <a:ext cx="37957" cy="0"/>
            </a:xfrm>
            <a:custGeom>
              <a:avLst/>
              <a:pathLst>
                <a:path w="37957" h="0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5"/>
            <p:cNvSpPr/>
            <p:nvPr/>
          </p:nvSpPr>
          <p:spPr>
            <a:xfrm>
              <a:off x="537644" y="1936098"/>
              <a:ext cx="37957" cy="0"/>
            </a:xfrm>
            <a:custGeom>
              <a:avLst/>
              <a:pathLst>
                <a:path w="37957" h="0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6"/>
            <p:cNvSpPr/>
            <p:nvPr/>
          </p:nvSpPr>
          <p:spPr>
            <a:xfrm>
              <a:off x="537644" y="1098130"/>
              <a:ext cx="37957" cy="0"/>
            </a:xfrm>
            <a:custGeom>
              <a:avLst/>
              <a:pathLst>
                <a:path w="37957" h="0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7"/>
            <p:cNvSpPr/>
            <p:nvPr/>
          </p:nvSpPr>
          <p:spPr>
            <a:xfrm>
              <a:off x="956125" y="2984969"/>
              <a:ext cx="0" cy="37957"/>
            </a:xfrm>
            <a:custGeom>
              <a:avLst/>
              <a:pathLst>
                <a:path w="0"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8"/>
            <p:cNvSpPr/>
            <p:nvPr/>
          </p:nvSpPr>
          <p:spPr>
            <a:xfrm>
              <a:off x="1480985" y="2984969"/>
              <a:ext cx="0" cy="37957"/>
            </a:xfrm>
            <a:custGeom>
              <a:avLst/>
              <a:pathLst>
                <a:path w="0"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9"/>
            <p:cNvSpPr/>
            <p:nvPr/>
          </p:nvSpPr>
          <p:spPr>
            <a:xfrm>
              <a:off x="2005846" y="2984969"/>
              <a:ext cx="0" cy="37957"/>
            </a:xfrm>
            <a:custGeom>
              <a:avLst/>
              <a:pathLst>
                <a:path w="0"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40"/>
            <p:cNvSpPr/>
            <p:nvPr/>
          </p:nvSpPr>
          <p:spPr>
            <a:xfrm>
              <a:off x="2530706" y="2984969"/>
              <a:ext cx="0" cy="37957"/>
            </a:xfrm>
            <a:custGeom>
              <a:avLst/>
              <a:pathLst>
                <a:path w="0"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1"/>
            <p:cNvSpPr/>
            <p:nvPr/>
          </p:nvSpPr>
          <p:spPr>
            <a:xfrm>
              <a:off x="3055566" y="2984969"/>
              <a:ext cx="0" cy="37957"/>
            </a:xfrm>
            <a:custGeom>
              <a:avLst/>
              <a:pathLst>
                <a:path w="0"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tx42"/>
            <p:cNvSpPr/>
            <p:nvPr/>
          </p:nvSpPr>
          <p:spPr>
            <a:xfrm>
              <a:off x="871452" y="3053293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1</a:t>
              </a:r>
            </a:p>
          </p:txBody>
        </p:sp>
        <p:sp>
          <p:nvSpPr>
            <p:cNvPr id="43" name="tx43"/>
            <p:cNvSpPr/>
            <p:nvPr/>
          </p:nvSpPr>
          <p:spPr>
            <a:xfrm>
              <a:off x="1396312" y="3053293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</a:t>
              </a:r>
            </a:p>
          </p:txBody>
        </p:sp>
        <p:sp>
          <p:nvSpPr>
            <p:cNvPr id="44" name="tx44"/>
            <p:cNvSpPr/>
            <p:nvPr/>
          </p:nvSpPr>
          <p:spPr>
            <a:xfrm>
              <a:off x="1921172" y="3053293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3</a:t>
              </a:r>
            </a:p>
          </p:txBody>
        </p:sp>
        <p:sp>
          <p:nvSpPr>
            <p:cNvPr id="45" name="tx45"/>
            <p:cNvSpPr/>
            <p:nvPr/>
          </p:nvSpPr>
          <p:spPr>
            <a:xfrm>
              <a:off x="2446032" y="3053293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4</a:t>
              </a:r>
            </a:p>
          </p:txBody>
        </p:sp>
        <p:sp>
          <p:nvSpPr>
            <p:cNvPr id="46" name="tx46"/>
            <p:cNvSpPr/>
            <p:nvPr/>
          </p:nvSpPr>
          <p:spPr>
            <a:xfrm>
              <a:off x="2970893" y="3053293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</a:t>
              </a:r>
            </a:p>
          </p:txBody>
        </p:sp>
        <p:sp>
          <p:nvSpPr>
            <p:cNvPr id="47" name="tx47"/>
            <p:cNvSpPr/>
            <p:nvPr/>
          </p:nvSpPr>
          <p:spPr>
            <a:xfrm>
              <a:off x="1167251" y="3210377"/>
              <a:ext cx="1414759" cy="10917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2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hreshold probability</a:t>
              </a:r>
            </a:p>
          </p:txBody>
        </p:sp>
        <p:sp>
          <p:nvSpPr>
            <p:cNvPr id="48" name="tx48"/>
            <p:cNvSpPr/>
            <p:nvPr/>
          </p:nvSpPr>
          <p:spPr>
            <a:xfrm rot="-5400000">
              <a:off x="-238043" y="1597010"/>
              <a:ext cx="737097" cy="10917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2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et benefit</a:t>
              </a:r>
            </a:p>
          </p:txBody>
        </p:sp>
        <p:sp>
          <p:nvSpPr>
            <p:cNvPr id="49" name="rc49"/>
            <p:cNvSpPr/>
            <p:nvPr/>
          </p:nvSpPr>
          <p:spPr>
            <a:xfrm>
              <a:off x="3325490" y="917611"/>
              <a:ext cx="1170593" cy="1467977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50" name="tx50"/>
            <p:cNvSpPr/>
            <p:nvPr/>
          </p:nvSpPr>
          <p:spPr>
            <a:xfrm>
              <a:off x="3401406" y="1010413"/>
              <a:ext cx="415137" cy="10917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2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odel</a:t>
              </a:r>
            </a:p>
          </p:txBody>
        </p:sp>
        <p:sp>
          <p:nvSpPr>
            <p:cNvPr id="51" name="rc51"/>
            <p:cNvSpPr/>
            <p:nvPr/>
          </p:nvSpPr>
          <p:spPr>
            <a:xfrm>
              <a:off x="3401406" y="1212393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52" name="pl52"/>
            <p:cNvSpPr/>
            <p:nvPr/>
          </p:nvSpPr>
          <p:spPr>
            <a:xfrm>
              <a:off x="3423351" y="1322121"/>
              <a:ext cx="175564" cy="0"/>
            </a:xfrm>
            <a:custGeom>
              <a:avLst/>
              <a:pathLst>
                <a:path w="175564" h="0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21681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rc53"/>
            <p:cNvSpPr/>
            <p:nvPr/>
          </p:nvSpPr>
          <p:spPr>
            <a:xfrm>
              <a:off x="3401406" y="1431849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54" name="pl54"/>
            <p:cNvSpPr/>
            <p:nvPr/>
          </p:nvSpPr>
          <p:spPr>
            <a:xfrm>
              <a:off x="3423351" y="1541577"/>
              <a:ext cx="175564" cy="0"/>
            </a:xfrm>
            <a:custGeom>
              <a:avLst/>
              <a:pathLst>
                <a:path w="175564" h="0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21681" cap="flat">
              <a:solidFill>
                <a:srgbClr val="A3A5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rc55"/>
            <p:cNvSpPr/>
            <p:nvPr/>
          </p:nvSpPr>
          <p:spPr>
            <a:xfrm>
              <a:off x="3401406" y="1651305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56" name="pl56"/>
            <p:cNvSpPr/>
            <p:nvPr/>
          </p:nvSpPr>
          <p:spPr>
            <a:xfrm>
              <a:off x="3423351" y="1761033"/>
              <a:ext cx="175564" cy="0"/>
            </a:xfrm>
            <a:custGeom>
              <a:avLst/>
              <a:pathLst>
                <a:path w="175564" h="0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21681" cap="flat">
              <a:solidFill>
                <a:srgbClr val="00BF7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rc57"/>
            <p:cNvSpPr/>
            <p:nvPr/>
          </p:nvSpPr>
          <p:spPr>
            <a:xfrm>
              <a:off x="3401406" y="1870761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58" name="pl58"/>
            <p:cNvSpPr/>
            <p:nvPr/>
          </p:nvSpPr>
          <p:spPr>
            <a:xfrm>
              <a:off x="3423351" y="1980489"/>
              <a:ext cx="175564" cy="0"/>
            </a:xfrm>
            <a:custGeom>
              <a:avLst/>
              <a:pathLst>
                <a:path w="175564" h="0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21681" cap="flat">
              <a:solidFill>
                <a:srgbClr val="00B0F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rc59"/>
            <p:cNvSpPr/>
            <p:nvPr/>
          </p:nvSpPr>
          <p:spPr>
            <a:xfrm>
              <a:off x="3401406" y="2090217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60" name="pl60"/>
            <p:cNvSpPr/>
            <p:nvPr/>
          </p:nvSpPr>
          <p:spPr>
            <a:xfrm>
              <a:off x="3423351" y="2199945"/>
              <a:ext cx="175564" cy="0"/>
            </a:xfrm>
            <a:custGeom>
              <a:avLst/>
              <a:pathLst>
                <a:path w="175564" h="0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21681" cap="flat">
              <a:solidFill>
                <a:srgbClr val="E76BF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tx61"/>
            <p:cNvSpPr/>
            <p:nvPr/>
          </p:nvSpPr>
          <p:spPr>
            <a:xfrm>
              <a:off x="3696777" y="1276630"/>
              <a:ext cx="183520" cy="9098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FLI</a:t>
              </a:r>
            </a:p>
          </p:txBody>
        </p:sp>
        <p:sp>
          <p:nvSpPr>
            <p:cNvPr id="62" name="tx62"/>
            <p:cNvSpPr/>
            <p:nvPr/>
          </p:nvSpPr>
          <p:spPr>
            <a:xfrm>
              <a:off x="3696777" y="1496086"/>
              <a:ext cx="211683" cy="9098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HSI</a:t>
              </a:r>
            </a:p>
          </p:txBody>
        </p:sp>
        <p:sp>
          <p:nvSpPr>
            <p:cNvPr id="63" name="tx63"/>
            <p:cNvSpPr/>
            <p:nvPr/>
          </p:nvSpPr>
          <p:spPr>
            <a:xfrm>
              <a:off x="3696777" y="1715542"/>
              <a:ext cx="691560" cy="9098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AFLD-LFS</a:t>
              </a:r>
            </a:p>
          </p:txBody>
        </p:sp>
        <p:sp>
          <p:nvSpPr>
            <p:cNvPr id="64" name="tx64"/>
            <p:cNvSpPr/>
            <p:nvPr/>
          </p:nvSpPr>
          <p:spPr>
            <a:xfrm>
              <a:off x="3696777" y="1934998"/>
              <a:ext cx="480151" cy="9098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LDLD1</a:t>
              </a:r>
            </a:p>
          </p:txBody>
        </p:sp>
        <p:sp>
          <p:nvSpPr>
            <p:cNvPr id="65" name="tx65"/>
            <p:cNvSpPr/>
            <p:nvPr/>
          </p:nvSpPr>
          <p:spPr>
            <a:xfrm>
              <a:off x="3696777" y="2154454"/>
              <a:ext cx="402244" cy="9098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US-FLI</a:t>
              </a:r>
            </a:p>
          </p:txBody>
        </p:sp>
        <p:sp>
          <p:nvSpPr>
            <p:cNvPr id="66" name="tx66"/>
            <p:cNvSpPr/>
            <p:nvPr/>
          </p:nvSpPr>
          <p:spPr>
            <a:xfrm>
              <a:off x="575602" y="75915"/>
              <a:ext cx="2351196" cy="12728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4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Decision Curve Analysis: Men</a:t>
              </a:r>
            </a:p>
          </p:txBody>
        </p:sp>
        <p:sp>
          <p:nvSpPr>
            <p:cNvPr id="67" name="rc67"/>
            <p:cNvSpPr/>
            <p:nvPr/>
          </p:nvSpPr>
          <p:spPr>
            <a:xfrm>
              <a:off x="4571999" y="0"/>
              <a:ext cx="4572000" cy="342899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4782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rc68"/>
            <p:cNvSpPr/>
            <p:nvPr/>
          </p:nvSpPr>
          <p:spPr>
            <a:xfrm>
              <a:off x="5147602" y="318231"/>
              <a:ext cx="2598057" cy="2666738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69" name="pl69"/>
            <p:cNvSpPr/>
            <p:nvPr/>
          </p:nvSpPr>
          <p:spPr>
            <a:xfrm>
              <a:off x="5147602" y="2692278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70"/>
            <p:cNvSpPr/>
            <p:nvPr/>
          </p:nvSpPr>
          <p:spPr>
            <a:xfrm>
              <a:off x="5147602" y="1931353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1"/>
            <p:cNvSpPr/>
            <p:nvPr/>
          </p:nvSpPr>
          <p:spPr>
            <a:xfrm>
              <a:off x="5147602" y="1170428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2"/>
            <p:cNvSpPr/>
            <p:nvPr/>
          </p:nvSpPr>
          <p:spPr>
            <a:xfrm>
              <a:off x="5147602" y="409504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3"/>
            <p:cNvSpPr/>
            <p:nvPr/>
          </p:nvSpPr>
          <p:spPr>
            <a:xfrm>
              <a:off x="5265695" y="318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4"/>
            <p:cNvSpPr/>
            <p:nvPr/>
          </p:nvSpPr>
          <p:spPr>
            <a:xfrm>
              <a:off x="5790555" y="318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5"/>
            <p:cNvSpPr/>
            <p:nvPr/>
          </p:nvSpPr>
          <p:spPr>
            <a:xfrm>
              <a:off x="6315416" y="318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6"/>
            <p:cNvSpPr/>
            <p:nvPr/>
          </p:nvSpPr>
          <p:spPr>
            <a:xfrm>
              <a:off x="6840276" y="318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7"/>
            <p:cNvSpPr/>
            <p:nvPr/>
          </p:nvSpPr>
          <p:spPr>
            <a:xfrm>
              <a:off x="7365136" y="318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8"/>
            <p:cNvSpPr/>
            <p:nvPr/>
          </p:nvSpPr>
          <p:spPr>
            <a:xfrm>
              <a:off x="5147602" y="2311816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9"/>
            <p:cNvSpPr/>
            <p:nvPr/>
          </p:nvSpPr>
          <p:spPr>
            <a:xfrm>
              <a:off x="5147602" y="1550891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80"/>
            <p:cNvSpPr/>
            <p:nvPr/>
          </p:nvSpPr>
          <p:spPr>
            <a:xfrm>
              <a:off x="5147602" y="789966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1"/>
            <p:cNvSpPr/>
            <p:nvPr/>
          </p:nvSpPr>
          <p:spPr>
            <a:xfrm>
              <a:off x="5528125" y="318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2"/>
            <p:cNvSpPr/>
            <p:nvPr/>
          </p:nvSpPr>
          <p:spPr>
            <a:xfrm>
              <a:off x="6052985" y="318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3"/>
            <p:cNvSpPr/>
            <p:nvPr/>
          </p:nvSpPr>
          <p:spPr>
            <a:xfrm>
              <a:off x="6577846" y="318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4"/>
            <p:cNvSpPr/>
            <p:nvPr/>
          </p:nvSpPr>
          <p:spPr>
            <a:xfrm>
              <a:off x="7102706" y="318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5"/>
            <p:cNvSpPr/>
            <p:nvPr/>
          </p:nvSpPr>
          <p:spPr>
            <a:xfrm>
              <a:off x="7627566" y="318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6"/>
            <p:cNvSpPr/>
            <p:nvPr/>
          </p:nvSpPr>
          <p:spPr>
            <a:xfrm>
              <a:off x="5265695" y="575762"/>
              <a:ext cx="2361870" cy="1100163"/>
            </a:xfrm>
            <a:custGeom>
              <a:avLst/>
              <a:pathLst>
                <a:path w="2361870" h="1100163">
                  <a:moveTo>
                    <a:pt x="0" y="0"/>
                  </a:moveTo>
                  <a:lnTo>
                    <a:pt x="52486" y="42975"/>
                  </a:lnTo>
                  <a:lnTo>
                    <a:pt x="104972" y="94076"/>
                  </a:lnTo>
                  <a:lnTo>
                    <a:pt x="157458" y="131339"/>
                  </a:lnTo>
                  <a:lnTo>
                    <a:pt x="209944" y="161618"/>
                  </a:lnTo>
                  <a:lnTo>
                    <a:pt x="262430" y="188204"/>
                  </a:lnTo>
                  <a:lnTo>
                    <a:pt x="314916" y="235758"/>
                  </a:lnTo>
                  <a:lnTo>
                    <a:pt x="367402" y="263284"/>
                  </a:lnTo>
                  <a:lnTo>
                    <a:pt x="419888" y="294265"/>
                  </a:lnTo>
                  <a:lnTo>
                    <a:pt x="472374" y="331470"/>
                  </a:lnTo>
                  <a:lnTo>
                    <a:pt x="524860" y="361776"/>
                  </a:lnTo>
                  <a:lnTo>
                    <a:pt x="577346" y="395036"/>
                  </a:lnTo>
                  <a:lnTo>
                    <a:pt x="629832" y="419413"/>
                  </a:lnTo>
                  <a:lnTo>
                    <a:pt x="682318" y="443405"/>
                  </a:lnTo>
                  <a:lnTo>
                    <a:pt x="734804" y="462310"/>
                  </a:lnTo>
                  <a:lnTo>
                    <a:pt x="787290" y="476106"/>
                  </a:lnTo>
                  <a:lnTo>
                    <a:pt x="839776" y="498448"/>
                  </a:lnTo>
                  <a:lnTo>
                    <a:pt x="892262" y="529034"/>
                  </a:lnTo>
                  <a:lnTo>
                    <a:pt x="944748" y="559777"/>
                  </a:lnTo>
                  <a:lnTo>
                    <a:pt x="997234" y="584513"/>
                  </a:lnTo>
                  <a:lnTo>
                    <a:pt x="1049720" y="613421"/>
                  </a:lnTo>
                  <a:lnTo>
                    <a:pt x="1102206" y="639128"/>
                  </a:lnTo>
                  <a:lnTo>
                    <a:pt x="1154692" y="663521"/>
                  </a:lnTo>
                  <a:lnTo>
                    <a:pt x="1207178" y="681148"/>
                  </a:lnTo>
                  <a:lnTo>
                    <a:pt x="1259664" y="695624"/>
                  </a:lnTo>
                  <a:lnTo>
                    <a:pt x="1312150" y="716766"/>
                  </a:lnTo>
                  <a:lnTo>
                    <a:pt x="1364636" y="736902"/>
                  </a:lnTo>
                  <a:lnTo>
                    <a:pt x="1417122" y="743972"/>
                  </a:lnTo>
                  <a:lnTo>
                    <a:pt x="1469608" y="770048"/>
                  </a:lnTo>
                  <a:lnTo>
                    <a:pt x="1522094" y="782299"/>
                  </a:lnTo>
                  <a:lnTo>
                    <a:pt x="1574580" y="798568"/>
                  </a:lnTo>
                  <a:lnTo>
                    <a:pt x="1627066" y="809904"/>
                  </a:lnTo>
                  <a:lnTo>
                    <a:pt x="1679552" y="831239"/>
                  </a:lnTo>
                  <a:lnTo>
                    <a:pt x="1732038" y="852975"/>
                  </a:lnTo>
                  <a:lnTo>
                    <a:pt x="1784524" y="878351"/>
                  </a:lnTo>
                  <a:lnTo>
                    <a:pt x="1837010" y="893260"/>
                  </a:lnTo>
                  <a:lnTo>
                    <a:pt x="1889496" y="913444"/>
                  </a:lnTo>
                  <a:lnTo>
                    <a:pt x="1941982" y="938018"/>
                  </a:lnTo>
                  <a:lnTo>
                    <a:pt x="1994468" y="959146"/>
                  </a:lnTo>
                  <a:lnTo>
                    <a:pt x="2046954" y="985973"/>
                  </a:lnTo>
                  <a:lnTo>
                    <a:pt x="2099440" y="1008823"/>
                  </a:lnTo>
                  <a:lnTo>
                    <a:pt x="2151926" y="1038638"/>
                  </a:lnTo>
                  <a:lnTo>
                    <a:pt x="2204412" y="1050200"/>
                  </a:lnTo>
                  <a:lnTo>
                    <a:pt x="2256898" y="1061347"/>
                  </a:lnTo>
                  <a:lnTo>
                    <a:pt x="2309384" y="1080812"/>
                  </a:lnTo>
                  <a:lnTo>
                    <a:pt x="2361870" y="1100163"/>
                  </a:lnTo>
                </a:path>
              </a:pathLst>
            </a:custGeom>
            <a:ln w="21681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7"/>
            <p:cNvSpPr/>
            <p:nvPr/>
          </p:nvSpPr>
          <p:spPr>
            <a:xfrm>
              <a:off x="5265695" y="439681"/>
              <a:ext cx="2361870" cy="1066554"/>
            </a:xfrm>
            <a:custGeom>
              <a:avLst/>
              <a:pathLst>
                <a:path w="2361870" h="1066554">
                  <a:moveTo>
                    <a:pt x="0" y="0"/>
                  </a:moveTo>
                  <a:lnTo>
                    <a:pt x="52486" y="28653"/>
                  </a:lnTo>
                  <a:lnTo>
                    <a:pt x="104972" y="57922"/>
                  </a:lnTo>
                  <a:lnTo>
                    <a:pt x="157458" y="87828"/>
                  </a:lnTo>
                  <a:lnTo>
                    <a:pt x="209944" y="118391"/>
                  </a:lnTo>
                  <a:lnTo>
                    <a:pt x="262430" y="149634"/>
                  </a:lnTo>
                  <a:lnTo>
                    <a:pt x="314916" y="181578"/>
                  </a:lnTo>
                  <a:lnTo>
                    <a:pt x="367402" y="214248"/>
                  </a:lnTo>
                  <a:lnTo>
                    <a:pt x="419888" y="247670"/>
                  </a:lnTo>
                  <a:lnTo>
                    <a:pt x="472374" y="281868"/>
                  </a:lnTo>
                  <a:lnTo>
                    <a:pt x="524860" y="316872"/>
                  </a:lnTo>
                  <a:lnTo>
                    <a:pt x="577346" y="352709"/>
                  </a:lnTo>
                  <a:lnTo>
                    <a:pt x="629832" y="389409"/>
                  </a:lnTo>
                  <a:lnTo>
                    <a:pt x="682318" y="423083"/>
                  </a:lnTo>
                  <a:lnTo>
                    <a:pt x="734804" y="462937"/>
                  </a:lnTo>
                  <a:lnTo>
                    <a:pt x="787290" y="531808"/>
                  </a:lnTo>
                  <a:lnTo>
                    <a:pt x="839776" y="579303"/>
                  </a:lnTo>
                  <a:lnTo>
                    <a:pt x="892262" y="623208"/>
                  </a:lnTo>
                  <a:lnTo>
                    <a:pt x="944748" y="686869"/>
                  </a:lnTo>
                  <a:lnTo>
                    <a:pt x="997234" y="728820"/>
                  </a:lnTo>
                  <a:lnTo>
                    <a:pt x="1049720" y="761410"/>
                  </a:lnTo>
                  <a:lnTo>
                    <a:pt x="1102206" y="799226"/>
                  </a:lnTo>
                  <a:lnTo>
                    <a:pt x="1154692" y="823764"/>
                  </a:lnTo>
                  <a:lnTo>
                    <a:pt x="1207178" y="848984"/>
                  </a:lnTo>
                  <a:lnTo>
                    <a:pt x="1259664" y="865543"/>
                  </a:lnTo>
                  <a:lnTo>
                    <a:pt x="1312150" y="872623"/>
                  </a:lnTo>
                  <a:lnTo>
                    <a:pt x="1364636" y="861011"/>
                  </a:lnTo>
                  <a:lnTo>
                    <a:pt x="1417122" y="867182"/>
                  </a:lnTo>
                  <a:lnTo>
                    <a:pt x="1469608" y="865539"/>
                  </a:lnTo>
                  <a:lnTo>
                    <a:pt x="1522094" y="880085"/>
                  </a:lnTo>
                  <a:lnTo>
                    <a:pt x="1574580" y="891025"/>
                  </a:lnTo>
                  <a:lnTo>
                    <a:pt x="1627066" y="886817"/>
                  </a:lnTo>
                  <a:lnTo>
                    <a:pt x="1679552" y="903456"/>
                  </a:lnTo>
                  <a:lnTo>
                    <a:pt x="1732038" y="917319"/>
                  </a:lnTo>
                  <a:lnTo>
                    <a:pt x="1784524" y="941593"/>
                  </a:lnTo>
                  <a:lnTo>
                    <a:pt x="1837010" y="948962"/>
                  </a:lnTo>
                  <a:lnTo>
                    <a:pt x="1889496" y="950602"/>
                  </a:lnTo>
                  <a:lnTo>
                    <a:pt x="1941982" y="963385"/>
                  </a:lnTo>
                  <a:lnTo>
                    <a:pt x="1994468" y="985078"/>
                  </a:lnTo>
                  <a:lnTo>
                    <a:pt x="2046954" y="1002442"/>
                  </a:lnTo>
                  <a:lnTo>
                    <a:pt x="2099440" y="1002819"/>
                  </a:lnTo>
                  <a:lnTo>
                    <a:pt x="2151926" y="1003871"/>
                  </a:lnTo>
                  <a:lnTo>
                    <a:pt x="2204412" y="1021140"/>
                  </a:lnTo>
                  <a:lnTo>
                    <a:pt x="2256898" y="1035295"/>
                  </a:lnTo>
                  <a:lnTo>
                    <a:pt x="2309384" y="1049130"/>
                  </a:lnTo>
                  <a:lnTo>
                    <a:pt x="2361870" y="1066554"/>
                  </a:lnTo>
                </a:path>
              </a:pathLst>
            </a:custGeom>
            <a:ln w="21681" cap="flat">
              <a:solidFill>
                <a:srgbClr val="A3A5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8"/>
            <p:cNvSpPr/>
            <p:nvPr/>
          </p:nvSpPr>
          <p:spPr>
            <a:xfrm>
              <a:off x="5265695" y="439446"/>
              <a:ext cx="2361870" cy="923892"/>
            </a:xfrm>
            <a:custGeom>
              <a:avLst/>
              <a:pathLst>
                <a:path w="2361870" h="923892">
                  <a:moveTo>
                    <a:pt x="0" y="0"/>
                  </a:moveTo>
                  <a:lnTo>
                    <a:pt x="52486" y="28603"/>
                  </a:lnTo>
                  <a:lnTo>
                    <a:pt x="104972" y="57485"/>
                  </a:lnTo>
                  <a:lnTo>
                    <a:pt x="157458" y="86898"/>
                  </a:lnTo>
                  <a:lnTo>
                    <a:pt x="209944" y="117301"/>
                  </a:lnTo>
                  <a:lnTo>
                    <a:pt x="262430" y="146395"/>
                  </a:lnTo>
                  <a:lnTo>
                    <a:pt x="314916" y="181863"/>
                  </a:lnTo>
                  <a:lnTo>
                    <a:pt x="367402" y="217325"/>
                  </a:lnTo>
                  <a:lnTo>
                    <a:pt x="419888" y="256425"/>
                  </a:lnTo>
                  <a:lnTo>
                    <a:pt x="472374" y="295085"/>
                  </a:lnTo>
                  <a:lnTo>
                    <a:pt x="524860" y="338384"/>
                  </a:lnTo>
                  <a:lnTo>
                    <a:pt x="577346" y="369742"/>
                  </a:lnTo>
                  <a:lnTo>
                    <a:pt x="629832" y="409981"/>
                  </a:lnTo>
                  <a:lnTo>
                    <a:pt x="682318" y="444012"/>
                  </a:lnTo>
                  <a:lnTo>
                    <a:pt x="734804" y="465267"/>
                  </a:lnTo>
                  <a:lnTo>
                    <a:pt x="787290" y="499668"/>
                  </a:lnTo>
                  <a:lnTo>
                    <a:pt x="839776" y="520695"/>
                  </a:lnTo>
                  <a:lnTo>
                    <a:pt x="892262" y="561384"/>
                  </a:lnTo>
                  <a:lnTo>
                    <a:pt x="944748" y="578365"/>
                  </a:lnTo>
                  <a:lnTo>
                    <a:pt x="997234" y="602610"/>
                  </a:lnTo>
                  <a:lnTo>
                    <a:pt x="1049720" y="621725"/>
                  </a:lnTo>
                  <a:lnTo>
                    <a:pt x="1102206" y="648478"/>
                  </a:lnTo>
                  <a:lnTo>
                    <a:pt x="1154692" y="650945"/>
                  </a:lnTo>
                  <a:lnTo>
                    <a:pt x="1207178" y="678785"/>
                  </a:lnTo>
                  <a:lnTo>
                    <a:pt x="1259664" y="684201"/>
                  </a:lnTo>
                  <a:lnTo>
                    <a:pt x="1312150" y="698065"/>
                  </a:lnTo>
                  <a:lnTo>
                    <a:pt x="1364636" y="701846"/>
                  </a:lnTo>
                  <a:lnTo>
                    <a:pt x="1417122" y="735027"/>
                  </a:lnTo>
                  <a:lnTo>
                    <a:pt x="1469608" y="731475"/>
                  </a:lnTo>
                  <a:lnTo>
                    <a:pt x="1522094" y="738776"/>
                  </a:lnTo>
                  <a:lnTo>
                    <a:pt x="1574580" y="741836"/>
                  </a:lnTo>
                  <a:lnTo>
                    <a:pt x="1627066" y="765087"/>
                  </a:lnTo>
                  <a:lnTo>
                    <a:pt x="1679552" y="776105"/>
                  </a:lnTo>
                  <a:lnTo>
                    <a:pt x="1732038" y="789206"/>
                  </a:lnTo>
                  <a:lnTo>
                    <a:pt x="1784524" y="833411"/>
                  </a:lnTo>
                  <a:lnTo>
                    <a:pt x="1837010" y="831605"/>
                  </a:lnTo>
                  <a:lnTo>
                    <a:pt x="1889496" y="846162"/>
                  </a:lnTo>
                  <a:lnTo>
                    <a:pt x="1941982" y="863993"/>
                  </a:lnTo>
                  <a:lnTo>
                    <a:pt x="1994468" y="877200"/>
                  </a:lnTo>
                  <a:lnTo>
                    <a:pt x="2046954" y="886892"/>
                  </a:lnTo>
                  <a:lnTo>
                    <a:pt x="2099440" y="898317"/>
                  </a:lnTo>
                  <a:lnTo>
                    <a:pt x="2151926" y="906692"/>
                  </a:lnTo>
                  <a:lnTo>
                    <a:pt x="2204412" y="914034"/>
                  </a:lnTo>
                  <a:lnTo>
                    <a:pt x="2256898" y="918053"/>
                  </a:lnTo>
                  <a:lnTo>
                    <a:pt x="2309384" y="917238"/>
                  </a:lnTo>
                  <a:lnTo>
                    <a:pt x="2361870" y="923892"/>
                  </a:lnTo>
                </a:path>
              </a:pathLst>
            </a:custGeom>
            <a:ln w="21681" cap="flat">
              <a:solidFill>
                <a:srgbClr val="00BF7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9"/>
            <p:cNvSpPr/>
            <p:nvPr/>
          </p:nvSpPr>
          <p:spPr>
            <a:xfrm>
              <a:off x="5265695" y="439681"/>
              <a:ext cx="2361870" cy="863066"/>
            </a:xfrm>
            <a:custGeom>
              <a:avLst/>
              <a:pathLst>
                <a:path w="2361870" h="863066">
                  <a:moveTo>
                    <a:pt x="0" y="0"/>
                  </a:moveTo>
                  <a:lnTo>
                    <a:pt x="52486" y="28083"/>
                  </a:lnTo>
                  <a:lnTo>
                    <a:pt x="104972" y="56242"/>
                  </a:lnTo>
                  <a:lnTo>
                    <a:pt x="157458" y="84722"/>
                  </a:lnTo>
                  <a:lnTo>
                    <a:pt x="209944" y="113533"/>
                  </a:lnTo>
                  <a:lnTo>
                    <a:pt x="262430" y="143183"/>
                  </a:lnTo>
                  <a:lnTo>
                    <a:pt x="314916" y="170540"/>
                  </a:lnTo>
                  <a:lnTo>
                    <a:pt x="367402" y="199025"/>
                  </a:lnTo>
                  <a:lnTo>
                    <a:pt x="419888" y="234581"/>
                  </a:lnTo>
                  <a:lnTo>
                    <a:pt x="472374" y="271380"/>
                  </a:lnTo>
                  <a:lnTo>
                    <a:pt x="524860" y="301111"/>
                  </a:lnTo>
                  <a:lnTo>
                    <a:pt x="577346" y="348456"/>
                  </a:lnTo>
                  <a:lnTo>
                    <a:pt x="629832" y="381285"/>
                  </a:lnTo>
                  <a:lnTo>
                    <a:pt x="682318" y="421885"/>
                  </a:lnTo>
                  <a:lnTo>
                    <a:pt x="734804" y="439727"/>
                  </a:lnTo>
                  <a:lnTo>
                    <a:pt x="787290" y="489385"/>
                  </a:lnTo>
                  <a:lnTo>
                    <a:pt x="839776" y="543805"/>
                  </a:lnTo>
                  <a:lnTo>
                    <a:pt x="892262" y="557943"/>
                  </a:lnTo>
                  <a:lnTo>
                    <a:pt x="944748" y="591701"/>
                  </a:lnTo>
                  <a:lnTo>
                    <a:pt x="997234" y="610131"/>
                  </a:lnTo>
                  <a:lnTo>
                    <a:pt x="1049720" y="615536"/>
                  </a:lnTo>
                  <a:lnTo>
                    <a:pt x="1102206" y="629416"/>
                  </a:lnTo>
                  <a:lnTo>
                    <a:pt x="1154692" y="643920"/>
                  </a:lnTo>
                  <a:lnTo>
                    <a:pt x="1207178" y="651509"/>
                  </a:lnTo>
                  <a:lnTo>
                    <a:pt x="1259664" y="667110"/>
                  </a:lnTo>
                  <a:lnTo>
                    <a:pt x="1312150" y="676140"/>
                  </a:lnTo>
                  <a:lnTo>
                    <a:pt x="1364636" y="689120"/>
                  </a:lnTo>
                  <a:lnTo>
                    <a:pt x="1417122" y="686722"/>
                  </a:lnTo>
                  <a:lnTo>
                    <a:pt x="1469608" y="684719"/>
                  </a:lnTo>
                  <a:lnTo>
                    <a:pt x="1522094" y="695374"/>
                  </a:lnTo>
                  <a:lnTo>
                    <a:pt x="1574580" y="722709"/>
                  </a:lnTo>
                  <a:lnTo>
                    <a:pt x="1627066" y="740571"/>
                  </a:lnTo>
                  <a:lnTo>
                    <a:pt x="1679552" y="740146"/>
                  </a:lnTo>
                  <a:lnTo>
                    <a:pt x="1732038" y="751231"/>
                  </a:lnTo>
                  <a:lnTo>
                    <a:pt x="1784524" y="787129"/>
                  </a:lnTo>
                  <a:lnTo>
                    <a:pt x="1837010" y="786715"/>
                  </a:lnTo>
                  <a:lnTo>
                    <a:pt x="1889496" y="797033"/>
                  </a:lnTo>
                  <a:lnTo>
                    <a:pt x="1941982" y="798931"/>
                  </a:lnTo>
                  <a:lnTo>
                    <a:pt x="1994468" y="803167"/>
                  </a:lnTo>
                  <a:lnTo>
                    <a:pt x="2046954" y="819037"/>
                  </a:lnTo>
                  <a:lnTo>
                    <a:pt x="2099440" y="823386"/>
                  </a:lnTo>
                  <a:lnTo>
                    <a:pt x="2151926" y="837655"/>
                  </a:lnTo>
                  <a:lnTo>
                    <a:pt x="2204412" y="838391"/>
                  </a:lnTo>
                  <a:lnTo>
                    <a:pt x="2256898" y="854957"/>
                  </a:lnTo>
                  <a:lnTo>
                    <a:pt x="2309384" y="863066"/>
                  </a:lnTo>
                  <a:lnTo>
                    <a:pt x="2361870" y="861140"/>
                  </a:lnTo>
                </a:path>
              </a:pathLst>
            </a:custGeom>
            <a:ln w="21681" cap="flat">
              <a:solidFill>
                <a:srgbClr val="00B0F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90"/>
            <p:cNvSpPr/>
            <p:nvPr/>
          </p:nvSpPr>
          <p:spPr>
            <a:xfrm>
              <a:off x="5265695" y="1136772"/>
              <a:ext cx="2361870" cy="409652"/>
            </a:xfrm>
            <a:custGeom>
              <a:avLst/>
              <a:pathLst>
                <a:path w="2361870" h="409652">
                  <a:moveTo>
                    <a:pt x="0" y="0"/>
                  </a:moveTo>
                  <a:lnTo>
                    <a:pt x="52486" y="52031"/>
                  </a:lnTo>
                  <a:lnTo>
                    <a:pt x="104972" y="98650"/>
                  </a:lnTo>
                  <a:lnTo>
                    <a:pt x="157458" y="143857"/>
                  </a:lnTo>
                  <a:lnTo>
                    <a:pt x="209944" y="169790"/>
                  </a:lnTo>
                  <a:lnTo>
                    <a:pt x="262430" y="196796"/>
                  </a:lnTo>
                  <a:lnTo>
                    <a:pt x="314916" y="218689"/>
                  </a:lnTo>
                  <a:lnTo>
                    <a:pt x="367402" y="223115"/>
                  </a:lnTo>
                  <a:lnTo>
                    <a:pt x="419888" y="263830"/>
                  </a:lnTo>
                  <a:lnTo>
                    <a:pt x="472374" y="263640"/>
                  </a:lnTo>
                  <a:lnTo>
                    <a:pt x="524860" y="283304"/>
                  </a:lnTo>
                  <a:lnTo>
                    <a:pt x="577346" y="287169"/>
                  </a:lnTo>
                  <a:lnTo>
                    <a:pt x="629832" y="296293"/>
                  </a:lnTo>
                  <a:lnTo>
                    <a:pt x="682318" y="314352"/>
                  </a:lnTo>
                  <a:lnTo>
                    <a:pt x="734804" y="326902"/>
                  </a:lnTo>
                  <a:lnTo>
                    <a:pt x="787290" y="334855"/>
                  </a:lnTo>
                  <a:lnTo>
                    <a:pt x="839776" y="348322"/>
                  </a:lnTo>
                  <a:lnTo>
                    <a:pt x="892262" y="348395"/>
                  </a:lnTo>
                  <a:lnTo>
                    <a:pt x="944748" y="357400"/>
                  </a:lnTo>
                  <a:lnTo>
                    <a:pt x="997234" y="357476"/>
                  </a:lnTo>
                  <a:lnTo>
                    <a:pt x="1049720" y="362020"/>
                  </a:lnTo>
                  <a:lnTo>
                    <a:pt x="1102206" y="375497"/>
                  </a:lnTo>
                  <a:lnTo>
                    <a:pt x="1154692" y="380045"/>
                  </a:lnTo>
                  <a:lnTo>
                    <a:pt x="1207178" y="380130"/>
                  </a:lnTo>
                  <a:lnTo>
                    <a:pt x="1259664" y="380218"/>
                  </a:lnTo>
                  <a:lnTo>
                    <a:pt x="1312150" y="380307"/>
                  </a:lnTo>
                  <a:lnTo>
                    <a:pt x="1364636" y="384865"/>
                  </a:lnTo>
                  <a:lnTo>
                    <a:pt x="1417122" y="384961"/>
                  </a:lnTo>
                  <a:lnTo>
                    <a:pt x="1469608" y="385059"/>
                  </a:lnTo>
                  <a:lnTo>
                    <a:pt x="1522094" y="389625"/>
                  </a:lnTo>
                  <a:lnTo>
                    <a:pt x="1574580" y="391790"/>
                  </a:lnTo>
                  <a:lnTo>
                    <a:pt x="1627066" y="405187"/>
                  </a:lnTo>
                  <a:lnTo>
                    <a:pt x="1679552" y="405187"/>
                  </a:lnTo>
                  <a:lnTo>
                    <a:pt x="1732038" y="405187"/>
                  </a:lnTo>
                  <a:lnTo>
                    <a:pt x="1784524" y="405187"/>
                  </a:lnTo>
                  <a:lnTo>
                    <a:pt x="1837010" y="405187"/>
                  </a:lnTo>
                  <a:lnTo>
                    <a:pt x="1889496" y="405187"/>
                  </a:lnTo>
                  <a:lnTo>
                    <a:pt x="1941982" y="405187"/>
                  </a:lnTo>
                  <a:lnTo>
                    <a:pt x="1994468" y="405187"/>
                  </a:lnTo>
                  <a:lnTo>
                    <a:pt x="2046954" y="409652"/>
                  </a:lnTo>
                  <a:lnTo>
                    <a:pt x="2099440" y="409652"/>
                  </a:lnTo>
                  <a:lnTo>
                    <a:pt x="2151926" y="409652"/>
                  </a:lnTo>
                  <a:lnTo>
                    <a:pt x="2204412" y="409652"/>
                  </a:lnTo>
                  <a:lnTo>
                    <a:pt x="2256898" y="409652"/>
                  </a:lnTo>
                  <a:lnTo>
                    <a:pt x="2309384" y="409652"/>
                  </a:lnTo>
                  <a:lnTo>
                    <a:pt x="2361870" y="409652"/>
                  </a:lnTo>
                </a:path>
              </a:pathLst>
            </a:custGeom>
            <a:ln w="21681" cap="flat">
              <a:solidFill>
                <a:srgbClr val="E76BF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1"/>
            <p:cNvSpPr/>
            <p:nvPr/>
          </p:nvSpPr>
          <p:spPr>
            <a:xfrm>
              <a:off x="5265695" y="439681"/>
              <a:ext cx="2361870" cy="2424072"/>
            </a:xfrm>
            <a:custGeom>
              <a:avLst/>
              <a:pathLst>
                <a:path w="2361870" h="2424072">
                  <a:moveTo>
                    <a:pt x="0" y="0"/>
                  </a:moveTo>
                  <a:lnTo>
                    <a:pt x="52486" y="28653"/>
                  </a:lnTo>
                  <a:lnTo>
                    <a:pt x="104972" y="57922"/>
                  </a:lnTo>
                  <a:lnTo>
                    <a:pt x="157458" y="87828"/>
                  </a:lnTo>
                  <a:lnTo>
                    <a:pt x="209944" y="118391"/>
                  </a:lnTo>
                  <a:lnTo>
                    <a:pt x="262430" y="149634"/>
                  </a:lnTo>
                  <a:lnTo>
                    <a:pt x="314916" y="181578"/>
                  </a:lnTo>
                  <a:lnTo>
                    <a:pt x="367402" y="214248"/>
                  </a:lnTo>
                  <a:lnTo>
                    <a:pt x="419888" y="247670"/>
                  </a:lnTo>
                  <a:lnTo>
                    <a:pt x="472374" y="281868"/>
                  </a:lnTo>
                  <a:lnTo>
                    <a:pt x="524860" y="316872"/>
                  </a:lnTo>
                  <a:lnTo>
                    <a:pt x="577346" y="352709"/>
                  </a:lnTo>
                  <a:lnTo>
                    <a:pt x="629832" y="389409"/>
                  </a:lnTo>
                  <a:lnTo>
                    <a:pt x="682318" y="427004"/>
                  </a:lnTo>
                  <a:lnTo>
                    <a:pt x="734804" y="465528"/>
                  </a:lnTo>
                  <a:lnTo>
                    <a:pt x="787290" y="505015"/>
                  </a:lnTo>
                  <a:lnTo>
                    <a:pt x="839776" y="545501"/>
                  </a:lnTo>
                  <a:lnTo>
                    <a:pt x="892262" y="587026"/>
                  </a:lnTo>
                  <a:lnTo>
                    <a:pt x="944748" y="629629"/>
                  </a:lnTo>
                  <a:lnTo>
                    <a:pt x="997234" y="673353"/>
                  </a:lnTo>
                  <a:lnTo>
                    <a:pt x="1049720" y="718243"/>
                  </a:lnTo>
                  <a:lnTo>
                    <a:pt x="1102206" y="764347"/>
                  </a:lnTo>
                  <a:lnTo>
                    <a:pt x="1154692" y="811713"/>
                  </a:lnTo>
                  <a:lnTo>
                    <a:pt x="1207178" y="860396"/>
                  </a:lnTo>
                  <a:lnTo>
                    <a:pt x="1259664" y="910449"/>
                  </a:lnTo>
                  <a:lnTo>
                    <a:pt x="1312150" y="961933"/>
                  </a:lnTo>
                  <a:lnTo>
                    <a:pt x="1364636" y="1014909"/>
                  </a:lnTo>
                  <a:lnTo>
                    <a:pt x="1417122" y="1069443"/>
                  </a:lnTo>
                  <a:lnTo>
                    <a:pt x="1469608" y="1125606"/>
                  </a:lnTo>
                  <a:lnTo>
                    <a:pt x="1522094" y="1183469"/>
                  </a:lnTo>
                  <a:lnTo>
                    <a:pt x="1574580" y="1243114"/>
                  </a:lnTo>
                  <a:lnTo>
                    <a:pt x="1627066" y="1304622"/>
                  </a:lnTo>
                  <a:lnTo>
                    <a:pt x="1679552" y="1368083"/>
                  </a:lnTo>
                  <a:lnTo>
                    <a:pt x="1732038" y="1433591"/>
                  </a:lnTo>
                  <a:lnTo>
                    <a:pt x="1784524" y="1501247"/>
                  </a:lnTo>
                  <a:lnTo>
                    <a:pt x="1837010" y="1571158"/>
                  </a:lnTo>
                  <a:lnTo>
                    <a:pt x="1889496" y="1643439"/>
                  </a:lnTo>
                  <a:lnTo>
                    <a:pt x="1941982" y="1718212"/>
                  </a:lnTo>
                  <a:lnTo>
                    <a:pt x="1994468" y="1795609"/>
                  </a:lnTo>
                  <a:lnTo>
                    <a:pt x="2046954" y="1875770"/>
                  </a:lnTo>
                  <a:lnTo>
                    <a:pt x="2099440" y="1958846"/>
                  </a:lnTo>
                  <a:lnTo>
                    <a:pt x="2151926" y="2044999"/>
                  </a:lnTo>
                  <a:lnTo>
                    <a:pt x="2204412" y="2134403"/>
                  </a:lnTo>
                  <a:lnTo>
                    <a:pt x="2256898" y="2227246"/>
                  </a:lnTo>
                  <a:lnTo>
                    <a:pt x="2309384" y="2323730"/>
                  </a:lnTo>
                  <a:lnTo>
                    <a:pt x="2361870" y="2424072"/>
                  </a:lnTo>
                </a:path>
              </a:pathLst>
            </a:custGeom>
            <a:ln w="21681" cap="flat">
              <a:solidFill>
                <a:srgbClr val="00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/>
          </p:txBody>
        </p:sp>
        <p:sp>
          <p:nvSpPr>
            <p:cNvPr id="92" name="pl92"/>
            <p:cNvSpPr/>
            <p:nvPr/>
          </p:nvSpPr>
          <p:spPr>
            <a:xfrm>
              <a:off x="5265695" y="1550891"/>
              <a:ext cx="2361870" cy="0"/>
            </a:xfrm>
            <a:custGeom>
              <a:avLst/>
              <a:pathLst>
                <a:path w="2361870" h="0">
                  <a:moveTo>
                    <a:pt x="0" y="0"/>
                  </a:moveTo>
                  <a:lnTo>
                    <a:pt x="52486" y="0"/>
                  </a:lnTo>
                  <a:lnTo>
                    <a:pt x="104972" y="0"/>
                  </a:lnTo>
                  <a:lnTo>
                    <a:pt x="157458" y="0"/>
                  </a:lnTo>
                  <a:lnTo>
                    <a:pt x="209944" y="0"/>
                  </a:lnTo>
                  <a:lnTo>
                    <a:pt x="262430" y="0"/>
                  </a:lnTo>
                  <a:lnTo>
                    <a:pt x="314916" y="0"/>
                  </a:lnTo>
                  <a:lnTo>
                    <a:pt x="367402" y="0"/>
                  </a:lnTo>
                  <a:lnTo>
                    <a:pt x="419888" y="0"/>
                  </a:lnTo>
                  <a:lnTo>
                    <a:pt x="472374" y="0"/>
                  </a:lnTo>
                  <a:lnTo>
                    <a:pt x="524860" y="0"/>
                  </a:lnTo>
                  <a:lnTo>
                    <a:pt x="577346" y="0"/>
                  </a:lnTo>
                  <a:lnTo>
                    <a:pt x="629832" y="0"/>
                  </a:lnTo>
                  <a:lnTo>
                    <a:pt x="682318" y="0"/>
                  </a:lnTo>
                  <a:lnTo>
                    <a:pt x="734804" y="0"/>
                  </a:lnTo>
                  <a:lnTo>
                    <a:pt x="787290" y="0"/>
                  </a:lnTo>
                  <a:lnTo>
                    <a:pt x="839776" y="0"/>
                  </a:lnTo>
                  <a:lnTo>
                    <a:pt x="892262" y="0"/>
                  </a:lnTo>
                  <a:lnTo>
                    <a:pt x="944748" y="0"/>
                  </a:lnTo>
                  <a:lnTo>
                    <a:pt x="997234" y="0"/>
                  </a:lnTo>
                  <a:lnTo>
                    <a:pt x="1049720" y="0"/>
                  </a:lnTo>
                  <a:lnTo>
                    <a:pt x="1102206" y="0"/>
                  </a:lnTo>
                  <a:lnTo>
                    <a:pt x="1154692" y="0"/>
                  </a:lnTo>
                  <a:lnTo>
                    <a:pt x="1207178" y="0"/>
                  </a:lnTo>
                  <a:lnTo>
                    <a:pt x="1259664" y="0"/>
                  </a:lnTo>
                  <a:lnTo>
                    <a:pt x="1312150" y="0"/>
                  </a:lnTo>
                  <a:lnTo>
                    <a:pt x="1364636" y="0"/>
                  </a:lnTo>
                  <a:lnTo>
                    <a:pt x="1417122" y="0"/>
                  </a:lnTo>
                  <a:lnTo>
                    <a:pt x="1469608" y="0"/>
                  </a:lnTo>
                  <a:lnTo>
                    <a:pt x="1522094" y="0"/>
                  </a:lnTo>
                  <a:lnTo>
                    <a:pt x="1574580" y="0"/>
                  </a:lnTo>
                  <a:lnTo>
                    <a:pt x="1627066" y="0"/>
                  </a:lnTo>
                  <a:lnTo>
                    <a:pt x="1679552" y="0"/>
                  </a:lnTo>
                  <a:lnTo>
                    <a:pt x="1732038" y="0"/>
                  </a:lnTo>
                  <a:lnTo>
                    <a:pt x="1784524" y="0"/>
                  </a:lnTo>
                  <a:lnTo>
                    <a:pt x="1837010" y="0"/>
                  </a:lnTo>
                  <a:lnTo>
                    <a:pt x="1889496" y="0"/>
                  </a:lnTo>
                  <a:lnTo>
                    <a:pt x="1941982" y="0"/>
                  </a:lnTo>
                  <a:lnTo>
                    <a:pt x="1994468" y="0"/>
                  </a:lnTo>
                  <a:lnTo>
                    <a:pt x="2046954" y="0"/>
                  </a:lnTo>
                  <a:lnTo>
                    <a:pt x="2099440" y="0"/>
                  </a:lnTo>
                  <a:lnTo>
                    <a:pt x="2151926" y="0"/>
                  </a:lnTo>
                  <a:lnTo>
                    <a:pt x="2204412" y="0"/>
                  </a:lnTo>
                  <a:lnTo>
                    <a:pt x="2256898" y="0"/>
                  </a:lnTo>
                  <a:lnTo>
                    <a:pt x="2309384" y="0"/>
                  </a:lnTo>
                  <a:lnTo>
                    <a:pt x="2361870" y="0"/>
                  </a:lnTo>
                </a:path>
              </a:pathLst>
            </a:custGeom>
            <a:ln w="21681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93" name="tx93"/>
            <p:cNvSpPr/>
            <p:nvPr/>
          </p:nvSpPr>
          <p:spPr>
            <a:xfrm>
              <a:off x="4726292" y="327283"/>
              <a:ext cx="337047" cy="18105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991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(B)</a:t>
              </a:r>
            </a:p>
          </p:txBody>
        </p:sp>
        <p:sp>
          <p:nvSpPr>
            <p:cNvPr id="94" name="rc94"/>
            <p:cNvSpPr/>
            <p:nvPr/>
          </p:nvSpPr>
          <p:spPr>
            <a:xfrm>
              <a:off x="5147602" y="318231"/>
              <a:ext cx="2598057" cy="2666738"/>
            </a:xfrm>
            <a:prstGeom prst="rect">
              <a:avLst/>
            </a:prstGeom>
            <a:noFill/>
            <a:ln w="14782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tx95"/>
            <p:cNvSpPr/>
            <p:nvPr/>
          </p:nvSpPr>
          <p:spPr>
            <a:xfrm>
              <a:off x="4869332" y="2268199"/>
              <a:ext cx="2099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2</a:t>
              </a:r>
            </a:p>
          </p:txBody>
        </p:sp>
        <p:sp>
          <p:nvSpPr>
            <p:cNvPr id="96" name="tx96"/>
            <p:cNvSpPr/>
            <p:nvPr/>
          </p:nvSpPr>
          <p:spPr>
            <a:xfrm>
              <a:off x="4909931" y="1507274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</a:t>
              </a:r>
            </a:p>
          </p:txBody>
        </p:sp>
        <p:sp>
          <p:nvSpPr>
            <p:cNvPr id="97" name="tx97"/>
            <p:cNvSpPr/>
            <p:nvPr/>
          </p:nvSpPr>
          <p:spPr>
            <a:xfrm>
              <a:off x="4909931" y="746349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</a:t>
              </a:r>
            </a:p>
          </p:txBody>
        </p:sp>
        <p:sp>
          <p:nvSpPr>
            <p:cNvPr id="98" name="pl98"/>
            <p:cNvSpPr/>
            <p:nvPr/>
          </p:nvSpPr>
          <p:spPr>
            <a:xfrm>
              <a:off x="5109644" y="2311816"/>
              <a:ext cx="37957" cy="0"/>
            </a:xfrm>
            <a:custGeom>
              <a:avLst/>
              <a:pathLst>
                <a:path w="37957" h="0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9"/>
            <p:cNvSpPr/>
            <p:nvPr/>
          </p:nvSpPr>
          <p:spPr>
            <a:xfrm>
              <a:off x="5109644" y="1550891"/>
              <a:ext cx="37957" cy="0"/>
            </a:xfrm>
            <a:custGeom>
              <a:avLst/>
              <a:pathLst>
                <a:path w="37957" h="0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100"/>
            <p:cNvSpPr/>
            <p:nvPr/>
          </p:nvSpPr>
          <p:spPr>
            <a:xfrm>
              <a:off x="5109644" y="789966"/>
              <a:ext cx="37957" cy="0"/>
            </a:xfrm>
            <a:custGeom>
              <a:avLst/>
              <a:pathLst>
                <a:path w="37957" h="0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1"/>
            <p:cNvSpPr/>
            <p:nvPr/>
          </p:nvSpPr>
          <p:spPr>
            <a:xfrm>
              <a:off x="5528125" y="2984969"/>
              <a:ext cx="0" cy="37957"/>
            </a:xfrm>
            <a:custGeom>
              <a:avLst/>
              <a:pathLst>
                <a:path w="0"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2"/>
            <p:cNvSpPr/>
            <p:nvPr/>
          </p:nvSpPr>
          <p:spPr>
            <a:xfrm>
              <a:off x="6052985" y="2984969"/>
              <a:ext cx="0" cy="37957"/>
            </a:xfrm>
            <a:custGeom>
              <a:avLst/>
              <a:pathLst>
                <a:path w="0"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3"/>
            <p:cNvSpPr/>
            <p:nvPr/>
          </p:nvSpPr>
          <p:spPr>
            <a:xfrm>
              <a:off x="6577846" y="2984969"/>
              <a:ext cx="0" cy="37957"/>
            </a:xfrm>
            <a:custGeom>
              <a:avLst/>
              <a:pathLst>
                <a:path w="0"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4"/>
            <p:cNvSpPr/>
            <p:nvPr/>
          </p:nvSpPr>
          <p:spPr>
            <a:xfrm>
              <a:off x="7102706" y="2984969"/>
              <a:ext cx="0" cy="37957"/>
            </a:xfrm>
            <a:custGeom>
              <a:avLst/>
              <a:pathLst>
                <a:path w="0"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5"/>
            <p:cNvSpPr/>
            <p:nvPr/>
          </p:nvSpPr>
          <p:spPr>
            <a:xfrm>
              <a:off x="7627566" y="2984969"/>
              <a:ext cx="0" cy="37957"/>
            </a:xfrm>
            <a:custGeom>
              <a:avLst/>
              <a:pathLst>
                <a:path w="0"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tx106"/>
            <p:cNvSpPr/>
            <p:nvPr/>
          </p:nvSpPr>
          <p:spPr>
            <a:xfrm>
              <a:off x="5443452" y="3053293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1</a:t>
              </a:r>
            </a:p>
          </p:txBody>
        </p:sp>
        <p:sp>
          <p:nvSpPr>
            <p:cNvPr id="107" name="tx107"/>
            <p:cNvSpPr/>
            <p:nvPr/>
          </p:nvSpPr>
          <p:spPr>
            <a:xfrm>
              <a:off x="5968312" y="3053293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</a:t>
              </a:r>
            </a:p>
          </p:txBody>
        </p:sp>
        <p:sp>
          <p:nvSpPr>
            <p:cNvPr id="108" name="tx108"/>
            <p:cNvSpPr/>
            <p:nvPr/>
          </p:nvSpPr>
          <p:spPr>
            <a:xfrm>
              <a:off x="6493172" y="3053293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3</a:t>
              </a:r>
            </a:p>
          </p:txBody>
        </p:sp>
        <p:sp>
          <p:nvSpPr>
            <p:cNvPr id="109" name="tx109"/>
            <p:cNvSpPr/>
            <p:nvPr/>
          </p:nvSpPr>
          <p:spPr>
            <a:xfrm>
              <a:off x="7018032" y="3053293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4</a:t>
              </a:r>
            </a:p>
          </p:txBody>
        </p:sp>
        <p:sp>
          <p:nvSpPr>
            <p:cNvPr id="110" name="tx110"/>
            <p:cNvSpPr/>
            <p:nvPr/>
          </p:nvSpPr>
          <p:spPr>
            <a:xfrm>
              <a:off x="7542893" y="3053293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</a:t>
              </a:r>
            </a:p>
          </p:txBody>
        </p:sp>
        <p:sp>
          <p:nvSpPr>
            <p:cNvPr id="111" name="tx111"/>
            <p:cNvSpPr/>
            <p:nvPr/>
          </p:nvSpPr>
          <p:spPr>
            <a:xfrm>
              <a:off x="5739251" y="3210377"/>
              <a:ext cx="1414759" cy="10917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2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hreshold probability</a:t>
              </a:r>
            </a:p>
          </p:txBody>
        </p:sp>
        <p:sp>
          <p:nvSpPr>
            <p:cNvPr id="112" name="tx112"/>
            <p:cNvSpPr/>
            <p:nvPr/>
          </p:nvSpPr>
          <p:spPr>
            <a:xfrm rot="-5400000">
              <a:off x="4333956" y="1597010"/>
              <a:ext cx="737097" cy="10917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2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et benefit</a:t>
              </a:r>
            </a:p>
          </p:txBody>
        </p:sp>
        <p:sp>
          <p:nvSpPr>
            <p:cNvPr id="113" name="rc113"/>
            <p:cNvSpPr/>
            <p:nvPr/>
          </p:nvSpPr>
          <p:spPr>
            <a:xfrm>
              <a:off x="7897490" y="917611"/>
              <a:ext cx="1170593" cy="1467977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14" name="tx114"/>
            <p:cNvSpPr/>
            <p:nvPr/>
          </p:nvSpPr>
          <p:spPr>
            <a:xfrm>
              <a:off x="7973406" y="1010413"/>
              <a:ext cx="415137" cy="10917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2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odel</a:t>
              </a:r>
            </a:p>
          </p:txBody>
        </p:sp>
        <p:sp>
          <p:nvSpPr>
            <p:cNvPr id="115" name="rc115"/>
            <p:cNvSpPr/>
            <p:nvPr/>
          </p:nvSpPr>
          <p:spPr>
            <a:xfrm>
              <a:off x="7973406" y="1212393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16" name="pl116"/>
            <p:cNvSpPr/>
            <p:nvPr/>
          </p:nvSpPr>
          <p:spPr>
            <a:xfrm>
              <a:off x="7995351" y="1322121"/>
              <a:ext cx="175564" cy="0"/>
            </a:xfrm>
            <a:custGeom>
              <a:avLst/>
              <a:pathLst>
                <a:path w="175564" h="0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21681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rc117"/>
            <p:cNvSpPr/>
            <p:nvPr/>
          </p:nvSpPr>
          <p:spPr>
            <a:xfrm>
              <a:off x="7973406" y="1431849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18" name="pl118"/>
            <p:cNvSpPr/>
            <p:nvPr/>
          </p:nvSpPr>
          <p:spPr>
            <a:xfrm>
              <a:off x="7995351" y="1541577"/>
              <a:ext cx="175564" cy="0"/>
            </a:xfrm>
            <a:custGeom>
              <a:avLst/>
              <a:pathLst>
                <a:path w="175564" h="0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21681" cap="flat">
              <a:solidFill>
                <a:srgbClr val="A3A5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rc119"/>
            <p:cNvSpPr/>
            <p:nvPr/>
          </p:nvSpPr>
          <p:spPr>
            <a:xfrm>
              <a:off x="7973406" y="1651305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20" name="pl120"/>
            <p:cNvSpPr/>
            <p:nvPr/>
          </p:nvSpPr>
          <p:spPr>
            <a:xfrm>
              <a:off x="7995351" y="1761033"/>
              <a:ext cx="175564" cy="0"/>
            </a:xfrm>
            <a:custGeom>
              <a:avLst/>
              <a:pathLst>
                <a:path w="175564" h="0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21681" cap="flat">
              <a:solidFill>
                <a:srgbClr val="00BF7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rc121"/>
            <p:cNvSpPr/>
            <p:nvPr/>
          </p:nvSpPr>
          <p:spPr>
            <a:xfrm>
              <a:off x="7973406" y="1870761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22" name="pl122"/>
            <p:cNvSpPr/>
            <p:nvPr/>
          </p:nvSpPr>
          <p:spPr>
            <a:xfrm>
              <a:off x="7995351" y="1980489"/>
              <a:ext cx="175564" cy="0"/>
            </a:xfrm>
            <a:custGeom>
              <a:avLst/>
              <a:pathLst>
                <a:path w="175564" h="0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21681" cap="flat">
              <a:solidFill>
                <a:srgbClr val="00B0F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rc123"/>
            <p:cNvSpPr/>
            <p:nvPr/>
          </p:nvSpPr>
          <p:spPr>
            <a:xfrm>
              <a:off x="7973406" y="2090217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24" name="pl124"/>
            <p:cNvSpPr/>
            <p:nvPr/>
          </p:nvSpPr>
          <p:spPr>
            <a:xfrm>
              <a:off x="7995351" y="2199945"/>
              <a:ext cx="175564" cy="0"/>
            </a:xfrm>
            <a:custGeom>
              <a:avLst/>
              <a:pathLst>
                <a:path w="175564" h="0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21681" cap="flat">
              <a:solidFill>
                <a:srgbClr val="E76BF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tx125"/>
            <p:cNvSpPr/>
            <p:nvPr/>
          </p:nvSpPr>
          <p:spPr>
            <a:xfrm>
              <a:off x="8268777" y="1276630"/>
              <a:ext cx="183520" cy="9098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FLI</a:t>
              </a:r>
            </a:p>
          </p:txBody>
        </p:sp>
        <p:sp>
          <p:nvSpPr>
            <p:cNvPr id="126" name="tx126"/>
            <p:cNvSpPr/>
            <p:nvPr/>
          </p:nvSpPr>
          <p:spPr>
            <a:xfrm>
              <a:off x="8268777" y="1496086"/>
              <a:ext cx="211683" cy="9098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HSI</a:t>
              </a:r>
            </a:p>
          </p:txBody>
        </p:sp>
        <p:sp>
          <p:nvSpPr>
            <p:cNvPr id="127" name="tx127"/>
            <p:cNvSpPr/>
            <p:nvPr/>
          </p:nvSpPr>
          <p:spPr>
            <a:xfrm>
              <a:off x="8268777" y="1715542"/>
              <a:ext cx="691560" cy="9098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AFLD-LFS</a:t>
              </a:r>
            </a:p>
          </p:txBody>
        </p:sp>
        <p:sp>
          <p:nvSpPr>
            <p:cNvPr id="128" name="tx128"/>
            <p:cNvSpPr/>
            <p:nvPr/>
          </p:nvSpPr>
          <p:spPr>
            <a:xfrm>
              <a:off x="8268777" y="1934998"/>
              <a:ext cx="480151" cy="9098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LDLD1</a:t>
              </a:r>
            </a:p>
          </p:txBody>
        </p:sp>
        <p:sp>
          <p:nvSpPr>
            <p:cNvPr id="129" name="tx129"/>
            <p:cNvSpPr/>
            <p:nvPr/>
          </p:nvSpPr>
          <p:spPr>
            <a:xfrm>
              <a:off x="8268777" y="2154454"/>
              <a:ext cx="402244" cy="9098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US-FLI</a:t>
              </a:r>
            </a:p>
          </p:txBody>
        </p:sp>
        <p:sp>
          <p:nvSpPr>
            <p:cNvPr id="130" name="tx130"/>
            <p:cNvSpPr/>
            <p:nvPr/>
          </p:nvSpPr>
          <p:spPr>
            <a:xfrm>
              <a:off x="5147602" y="75915"/>
              <a:ext cx="3894246" cy="12728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4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Decision Curve Analysis: Women aged &lt;55 years</a:t>
              </a:r>
            </a:p>
          </p:txBody>
        </p:sp>
        <p:sp>
          <p:nvSpPr>
            <p:cNvPr id="131" name="rc131"/>
            <p:cNvSpPr/>
            <p:nvPr/>
          </p:nvSpPr>
          <p:spPr>
            <a:xfrm>
              <a:off x="0" y="3429000"/>
              <a:ext cx="4572000" cy="3429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4782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rc132"/>
            <p:cNvSpPr/>
            <p:nvPr/>
          </p:nvSpPr>
          <p:spPr>
            <a:xfrm>
              <a:off x="575602" y="3747231"/>
              <a:ext cx="2598057" cy="2666738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33" name="pl133"/>
            <p:cNvSpPr/>
            <p:nvPr/>
          </p:nvSpPr>
          <p:spPr>
            <a:xfrm>
              <a:off x="575602" y="6028789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4"/>
            <p:cNvSpPr/>
            <p:nvPr/>
          </p:nvSpPr>
          <p:spPr>
            <a:xfrm>
              <a:off x="575602" y="5566851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5"/>
            <p:cNvSpPr/>
            <p:nvPr/>
          </p:nvSpPr>
          <p:spPr>
            <a:xfrm>
              <a:off x="575602" y="5104913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6"/>
            <p:cNvSpPr/>
            <p:nvPr/>
          </p:nvSpPr>
          <p:spPr>
            <a:xfrm>
              <a:off x="575602" y="4642974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7"/>
            <p:cNvSpPr/>
            <p:nvPr/>
          </p:nvSpPr>
          <p:spPr>
            <a:xfrm>
              <a:off x="575602" y="4181036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l138"/>
            <p:cNvSpPr/>
            <p:nvPr/>
          </p:nvSpPr>
          <p:spPr>
            <a:xfrm>
              <a:off x="693695" y="3747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l139"/>
            <p:cNvSpPr/>
            <p:nvPr/>
          </p:nvSpPr>
          <p:spPr>
            <a:xfrm>
              <a:off x="1218555" y="3747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l140"/>
            <p:cNvSpPr/>
            <p:nvPr/>
          </p:nvSpPr>
          <p:spPr>
            <a:xfrm>
              <a:off x="1743416" y="3747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1"/>
            <p:cNvSpPr/>
            <p:nvPr/>
          </p:nvSpPr>
          <p:spPr>
            <a:xfrm>
              <a:off x="2268276" y="3747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2"/>
            <p:cNvSpPr/>
            <p:nvPr/>
          </p:nvSpPr>
          <p:spPr>
            <a:xfrm>
              <a:off x="2793136" y="3747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813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3"/>
            <p:cNvSpPr/>
            <p:nvPr/>
          </p:nvSpPr>
          <p:spPr>
            <a:xfrm>
              <a:off x="575602" y="6259758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4"/>
            <p:cNvSpPr/>
            <p:nvPr/>
          </p:nvSpPr>
          <p:spPr>
            <a:xfrm>
              <a:off x="575602" y="5797820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5"/>
            <p:cNvSpPr/>
            <p:nvPr/>
          </p:nvSpPr>
          <p:spPr>
            <a:xfrm>
              <a:off x="575602" y="5335882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6"/>
            <p:cNvSpPr/>
            <p:nvPr/>
          </p:nvSpPr>
          <p:spPr>
            <a:xfrm>
              <a:off x="575602" y="4873943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7"/>
            <p:cNvSpPr/>
            <p:nvPr/>
          </p:nvSpPr>
          <p:spPr>
            <a:xfrm>
              <a:off x="575602" y="4412005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8"/>
            <p:cNvSpPr/>
            <p:nvPr/>
          </p:nvSpPr>
          <p:spPr>
            <a:xfrm>
              <a:off x="575602" y="3950067"/>
              <a:ext cx="2598057" cy="0"/>
            </a:xfrm>
            <a:custGeom>
              <a:avLst/>
              <a:pathLst>
                <a:path w="2598057" h="0">
                  <a:moveTo>
                    <a:pt x="0" y="0"/>
                  </a:moveTo>
                  <a:lnTo>
                    <a:pt x="2598057" y="0"/>
                  </a:lnTo>
                  <a:lnTo>
                    <a:pt x="2598057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9"/>
            <p:cNvSpPr/>
            <p:nvPr/>
          </p:nvSpPr>
          <p:spPr>
            <a:xfrm>
              <a:off x="956125" y="3747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50"/>
            <p:cNvSpPr/>
            <p:nvPr/>
          </p:nvSpPr>
          <p:spPr>
            <a:xfrm>
              <a:off x="1480985" y="3747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1"/>
            <p:cNvSpPr/>
            <p:nvPr/>
          </p:nvSpPr>
          <p:spPr>
            <a:xfrm>
              <a:off x="2005846" y="3747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2"/>
            <p:cNvSpPr/>
            <p:nvPr/>
          </p:nvSpPr>
          <p:spPr>
            <a:xfrm>
              <a:off x="2530706" y="3747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3"/>
            <p:cNvSpPr/>
            <p:nvPr/>
          </p:nvSpPr>
          <p:spPr>
            <a:xfrm>
              <a:off x="3055566" y="3747231"/>
              <a:ext cx="0" cy="2666738"/>
            </a:xfrm>
            <a:custGeom>
              <a:avLst/>
              <a:pathLst>
                <a:path w="0" h="2666738">
                  <a:moveTo>
                    <a:pt x="0" y="26667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0840" cap="flat">
              <a:solidFill>
                <a:srgbClr val="E0E0E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l154"/>
            <p:cNvSpPr/>
            <p:nvPr/>
          </p:nvSpPr>
          <p:spPr>
            <a:xfrm>
              <a:off x="693695" y="3881471"/>
              <a:ext cx="2361870" cy="1338926"/>
            </a:xfrm>
            <a:custGeom>
              <a:avLst/>
              <a:pathLst>
                <a:path w="2361870" h="1338926">
                  <a:moveTo>
                    <a:pt x="0" y="0"/>
                  </a:moveTo>
                  <a:lnTo>
                    <a:pt x="52486" y="25421"/>
                  </a:lnTo>
                  <a:lnTo>
                    <a:pt x="104972" y="84916"/>
                  </a:lnTo>
                  <a:lnTo>
                    <a:pt x="157458" y="107330"/>
                  </a:lnTo>
                  <a:lnTo>
                    <a:pt x="209944" y="133680"/>
                  </a:lnTo>
                  <a:lnTo>
                    <a:pt x="262430" y="176748"/>
                  </a:lnTo>
                  <a:lnTo>
                    <a:pt x="314916" y="197427"/>
                  </a:lnTo>
                  <a:lnTo>
                    <a:pt x="367402" y="219325"/>
                  </a:lnTo>
                  <a:lnTo>
                    <a:pt x="419888" y="243055"/>
                  </a:lnTo>
                  <a:lnTo>
                    <a:pt x="472374" y="283067"/>
                  </a:lnTo>
                  <a:lnTo>
                    <a:pt x="524860" y="306358"/>
                  </a:lnTo>
                  <a:lnTo>
                    <a:pt x="577346" y="326275"/>
                  </a:lnTo>
                  <a:lnTo>
                    <a:pt x="629832" y="345480"/>
                  </a:lnTo>
                  <a:lnTo>
                    <a:pt x="682318" y="380444"/>
                  </a:lnTo>
                  <a:lnTo>
                    <a:pt x="734804" y="409754"/>
                  </a:lnTo>
                  <a:lnTo>
                    <a:pt x="787290" y="435672"/>
                  </a:lnTo>
                  <a:lnTo>
                    <a:pt x="839776" y="473940"/>
                  </a:lnTo>
                  <a:lnTo>
                    <a:pt x="892262" y="490770"/>
                  </a:lnTo>
                  <a:lnTo>
                    <a:pt x="944748" y="533105"/>
                  </a:lnTo>
                  <a:lnTo>
                    <a:pt x="997234" y="565266"/>
                  </a:lnTo>
                  <a:lnTo>
                    <a:pt x="1049720" y="591026"/>
                  </a:lnTo>
                  <a:lnTo>
                    <a:pt x="1102206" y="627737"/>
                  </a:lnTo>
                  <a:lnTo>
                    <a:pt x="1154692" y="647601"/>
                  </a:lnTo>
                  <a:lnTo>
                    <a:pt x="1207178" y="679931"/>
                  </a:lnTo>
                  <a:lnTo>
                    <a:pt x="1259664" y="746167"/>
                  </a:lnTo>
                  <a:lnTo>
                    <a:pt x="1312150" y="787428"/>
                  </a:lnTo>
                  <a:lnTo>
                    <a:pt x="1364636" y="813148"/>
                  </a:lnTo>
                  <a:lnTo>
                    <a:pt x="1417122" y="839140"/>
                  </a:lnTo>
                  <a:lnTo>
                    <a:pt x="1469608" y="881912"/>
                  </a:lnTo>
                  <a:lnTo>
                    <a:pt x="1522094" y="916482"/>
                  </a:lnTo>
                  <a:lnTo>
                    <a:pt x="1574580" y="916329"/>
                  </a:lnTo>
                  <a:lnTo>
                    <a:pt x="1627066" y="951228"/>
                  </a:lnTo>
                  <a:lnTo>
                    <a:pt x="1679552" y="958167"/>
                  </a:lnTo>
                  <a:lnTo>
                    <a:pt x="1732038" y="973846"/>
                  </a:lnTo>
                  <a:lnTo>
                    <a:pt x="1784524" y="988956"/>
                  </a:lnTo>
                  <a:lnTo>
                    <a:pt x="1837010" y="1008970"/>
                  </a:lnTo>
                  <a:lnTo>
                    <a:pt x="1889496" y="1033857"/>
                  </a:lnTo>
                  <a:lnTo>
                    <a:pt x="1941982" y="1059032"/>
                  </a:lnTo>
                  <a:lnTo>
                    <a:pt x="1994468" y="1134006"/>
                  </a:lnTo>
                  <a:lnTo>
                    <a:pt x="2046954" y="1176305"/>
                  </a:lnTo>
                  <a:lnTo>
                    <a:pt x="2099440" y="1202444"/>
                  </a:lnTo>
                  <a:lnTo>
                    <a:pt x="2151926" y="1231385"/>
                  </a:lnTo>
                  <a:lnTo>
                    <a:pt x="2204412" y="1243052"/>
                  </a:lnTo>
                  <a:lnTo>
                    <a:pt x="2256898" y="1253899"/>
                  </a:lnTo>
                  <a:lnTo>
                    <a:pt x="2309384" y="1279728"/>
                  </a:lnTo>
                  <a:lnTo>
                    <a:pt x="2361870" y="1338926"/>
                  </a:lnTo>
                </a:path>
              </a:pathLst>
            </a:custGeom>
            <a:ln w="21681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l155"/>
            <p:cNvSpPr/>
            <p:nvPr/>
          </p:nvSpPr>
          <p:spPr>
            <a:xfrm>
              <a:off x="693695" y="3870183"/>
              <a:ext cx="2361870" cy="1350214"/>
            </a:xfrm>
            <a:custGeom>
              <a:avLst/>
              <a:pathLst>
                <a:path w="2361870" h="1350214">
                  <a:moveTo>
                    <a:pt x="0" y="0"/>
                  </a:moveTo>
                  <a:lnTo>
                    <a:pt x="52486" y="28635"/>
                  </a:lnTo>
                  <a:lnTo>
                    <a:pt x="104972" y="57887"/>
                  </a:lnTo>
                  <a:lnTo>
                    <a:pt x="157458" y="87774"/>
                  </a:lnTo>
                  <a:lnTo>
                    <a:pt x="209944" y="116686"/>
                  </a:lnTo>
                  <a:lnTo>
                    <a:pt x="262430" y="147708"/>
                  </a:lnTo>
                  <a:lnTo>
                    <a:pt x="314916" y="193885"/>
                  </a:lnTo>
                  <a:lnTo>
                    <a:pt x="367402" y="226114"/>
                  </a:lnTo>
                  <a:lnTo>
                    <a:pt x="419888" y="256619"/>
                  </a:lnTo>
                  <a:lnTo>
                    <a:pt x="472374" y="282078"/>
                  </a:lnTo>
                  <a:lnTo>
                    <a:pt x="524860" y="306971"/>
                  </a:lnTo>
                  <a:lnTo>
                    <a:pt x="577346" y="340706"/>
                  </a:lnTo>
                  <a:lnTo>
                    <a:pt x="629832" y="391752"/>
                  </a:lnTo>
                  <a:lnTo>
                    <a:pt x="682318" y="423521"/>
                  </a:lnTo>
                  <a:lnTo>
                    <a:pt x="734804" y="455667"/>
                  </a:lnTo>
                  <a:lnTo>
                    <a:pt x="787290" y="484080"/>
                  </a:lnTo>
                  <a:lnTo>
                    <a:pt x="839776" y="511332"/>
                  </a:lnTo>
                  <a:lnTo>
                    <a:pt x="892262" y="519825"/>
                  </a:lnTo>
                  <a:lnTo>
                    <a:pt x="944748" y="540751"/>
                  </a:lnTo>
                  <a:lnTo>
                    <a:pt x="997234" y="578291"/>
                  </a:lnTo>
                  <a:lnTo>
                    <a:pt x="1049720" y="591315"/>
                  </a:lnTo>
                  <a:lnTo>
                    <a:pt x="1102206" y="591315"/>
                  </a:lnTo>
                  <a:lnTo>
                    <a:pt x="1154692" y="666798"/>
                  </a:lnTo>
                  <a:lnTo>
                    <a:pt x="1207178" y="655473"/>
                  </a:lnTo>
                  <a:lnTo>
                    <a:pt x="1259664" y="684028"/>
                  </a:lnTo>
                  <a:lnTo>
                    <a:pt x="1312150" y="746866"/>
                  </a:lnTo>
                  <a:lnTo>
                    <a:pt x="1364636" y="812960"/>
                  </a:lnTo>
                  <a:lnTo>
                    <a:pt x="1417122" y="837812"/>
                  </a:lnTo>
                  <a:lnTo>
                    <a:pt x="1469608" y="844938"/>
                  </a:lnTo>
                  <a:lnTo>
                    <a:pt x="1522094" y="867278"/>
                  </a:lnTo>
                  <a:lnTo>
                    <a:pt x="1574580" y="888276"/>
                  </a:lnTo>
                  <a:lnTo>
                    <a:pt x="1627066" y="933645"/>
                  </a:lnTo>
                  <a:lnTo>
                    <a:pt x="1679552" y="971550"/>
                  </a:lnTo>
                  <a:lnTo>
                    <a:pt x="1732038" y="1037820"/>
                  </a:lnTo>
                  <a:lnTo>
                    <a:pt x="1784524" y="1036756"/>
                  </a:lnTo>
                  <a:lnTo>
                    <a:pt x="1837010" y="1064252"/>
                  </a:lnTo>
                  <a:lnTo>
                    <a:pt x="1889496" y="1056889"/>
                  </a:lnTo>
                  <a:lnTo>
                    <a:pt x="1941982" y="1113556"/>
                  </a:lnTo>
                  <a:lnTo>
                    <a:pt x="1994468" y="1135164"/>
                  </a:lnTo>
                  <a:lnTo>
                    <a:pt x="2046954" y="1167560"/>
                  </a:lnTo>
                  <a:lnTo>
                    <a:pt x="2099440" y="1225731"/>
                  </a:lnTo>
                  <a:lnTo>
                    <a:pt x="2151926" y="1195624"/>
                  </a:lnTo>
                  <a:lnTo>
                    <a:pt x="2204412" y="1257142"/>
                  </a:lnTo>
                  <a:lnTo>
                    <a:pt x="2256898" y="1300721"/>
                  </a:lnTo>
                  <a:lnTo>
                    <a:pt x="2309384" y="1310425"/>
                  </a:lnTo>
                  <a:lnTo>
                    <a:pt x="2361870" y="1350214"/>
                  </a:lnTo>
                </a:path>
              </a:pathLst>
            </a:custGeom>
            <a:ln w="21681" cap="flat">
              <a:solidFill>
                <a:srgbClr val="A3A5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l156"/>
            <p:cNvSpPr/>
            <p:nvPr/>
          </p:nvSpPr>
          <p:spPr>
            <a:xfrm>
              <a:off x="693695" y="3868446"/>
              <a:ext cx="2361870" cy="1335453"/>
            </a:xfrm>
            <a:custGeom>
              <a:avLst/>
              <a:pathLst>
                <a:path w="2361870" h="1335453">
                  <a:moveTo>
                    <a:pt x="0" y="0"/>
                  </a:moveTo>
                  <a:lnTo>
                    <a:pt x="52486" y="28266"/>
                  </a:lnTo>
                  <a:lnTo>
                    <a:pt x="104972" y="55898"/>
                  </a:lnTo>
                  <a:lnTo>
                    <a:pt x="157458" y="85207"/>
                  </a:lnTo>
                  <a:lnTo>
                    <a:pt x="209944" y="113528"/>
                  </a:lnTo>
                  <a:lnTo>
                    <a:pt x="262430" y="142112"/>
                  </a:lnTo>
                  <a:lnTo>
                    <a:pt x="314916" y="170968"/>
                  </a:lnTo>
                  <a:lnTo>
                    <a:pt x="367402" y="216602"/>
                  </a:lnTo>
                  <a:lnTo>
                    <a:pt x="419888" y="246029"/>
                  </a:lnTo>
                  <a:lnTo>
                    <a:pt x="472374" y="289569"/>
                  </a:lnTo>
                  <a:lnTo>
                    <a:pt x="524860" y="319383"/>
                  </a:lnTo>
                  <a:lnTo>
                    <a:pt x="577346" y="366011"/>
                  </a:lnTo>
                  <a:lnTo>
                    <a:pt x="629832" y="382953"/>
                  </a:lnTo>
                  <a:lnTo>
                    <a:pt x="682318" y="409162"/>
                  </a:lnTo>
                  <a:lnTo>
                    <a:pt x="734804" y="447831"/>
                  </a:lnTo>
                  <a:lnTo>
                    <a:pt x="787290" y="485816"/>
                  </a:lnTo>
                  <a:lnTo>
                    <a:pt x="839776" y="515366"/>
                  </a:lnTo>
                  <a:lnTo>
                    <a:pt x="892262" y="573593"/>
                  </a:lnTo>
                  <a:lnTo>
                    <a:pt x="944748" y="578911"/>
                  </a:lnTo>
                  <a:lnTo>
                    <a:pt x="997234" y="576554"/>
                  </a:lnTo>
                  <a:lnTo>
                    <a:pt x="1049720" y="642545"/>
                  </a:lnTo>
                  <a:lnTo>
                    <a:pt x="1102206" y="639870"/>
                  </a:lnTo>
                  <a:lnTo>
                    <a:pt x="1154692" y="663111"/>
                  </a:lnTo>
                  <a:lnTo>
                    <a:pt x="1207178" y="674624"/>
                  </a:lnTo>
                  <a:lnTo>
                    <a:pt x="1259664" y="670894"/>
                  </a:lnTo>
                  <a:lnTo>
                    <a:pt x="1312150" y="696752"/>
                  </a:lnTo>
                  <a:lnTo>
                    <a:pt x="1364636" y="718340"/>
                  </a:lnTo>
                  <a:lnTo>
                    <a:pt x="1417122" y="738621"/>
                  </a:lnTo>
                  <a:lnTo>
                    <a:pt x="1469608" y="774035"/>
                  </a:lnTo>
                  <a:lnTo>
                    <a:pt x="1522094" y="841519"/>
                  </a:lnTo>
                  <a:lnTo>
                    <a:pt x="1574580" y="850671"/>
                  </a:lnTo>
                  <a:lnTo>
                    <a:pt x="1627066" y="857017"/>
                  </a:lnTo>
                  <a:lnTo>
                    <a:pt x="1679552" y="880323"/>
                  </a:lnTo>
                  <a:lnTo>
                    <a:pt x="1732038" y="872450"/>
                  </a:lnTo>
                  <a:lnTo>
                    <a:pt x="1784524" y="904617"/>
                  </a:lnTo>
                  <a:lnTo>
                    <a:pt x="1837010" y="961503"/>
                  </a:lnTo>
                  <a:lnTo>
                    <a:pt x="1889496" y="1016402"/>
                  </a:lnTo>
                  <a:lnTo>
                    <a:pt x="1941982" y="1019719"/>
                  </a:lnTo>
                  <a:lnTo>
                    <a:pt x="1994468" y="1062226"/>
                  </a:lnTo>
                  <a:lnTo>
                    <a:pt x="2046954" y="1137479"/>
                  </a:lnTo>
                  <a:lnTo>
                    <a:pt x="2099440" y="1168975"/>
                  </a:lnTo>
                  <a:lnTo>
                    <a:pt x="2151926" y="1162531"/>
                  </a:lnTo>
                  <a:lnTo>
                    <a:pt x="2204412" y="1202225"/>
                  </a:lnTo>
                  <a:lnTo>
                    <a:pt x="2256898" y="1211085"/>
                  </a:lnTo>
                  <a:lnTo>
                    <a:pt x="2309384" y="1297605"/>
                  </a:lnTo>
                  <a:lnTo>
                    <a:pt x="2361870" y="1335453"/>
                  </a:lnTo>
                </a:path>
              </a:pathLst>
            </a:custGeom>
            <a:ln w="21681" cap="flat">
              <a:solidFill>
                <a:srgbClr val="00BF7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l157"/>
            <p:cNvSpPr/>
            <p:nvPr/>
          </p:nvSpPr>
          <p:spPr>
            <a:xfrm>
              <a:off x="693695" y="3880602"/>
              <a:ext cx="2361870" cy="1147735"/>
            </a:xfrm>
            <a:custGeom>
              <a:avLst/>
              <a:pathLst>
                <a:path w="2361870" h="1147735">
                  <a:moveTo>
                    <a:pt x="0" y="0"/>
                  </a:moveTo>
                  <a:lnTo>
                    <a:pt x="52486" y="25236"/>
                  </a:lnTo>
                  <a:lnTo>
                    <a:pt x="104972" y="51547"/>
                  </a:lnTo>
                  <a:lnTo>
                    <a:pt x="157458" y="78071"/>
                  </a:lnTo>
                  <a:lnTo>
                    <a:pt x="209944" y="101553"/>
                  </a:lnTo>
                  <a:lnTo>
                    <a:pt x="262430" y="161118"/>
                  </a:lnTo>
                  <a:lnTo>
                    <a:pt x="314916" y="187914"/>
                  </a:lnTo>
                  <a:lnTo>
                    <a:pt x="367402" y="208195"/>
                  </a:lnTo>
                  <a:lnTo>
                    <a:pt x="419888" y="232356"/>
                  </a:lnTo>
                  <a:lnTo>
                    <a:pt x="472374" y="261682"/>
                  </a:lnTo>
                  <a:lnTo>
                    <a:pt x="524860" y="277142"/>
                  </a:lnTo>
                  <a:lnTo>
                    <a:pt x="577346" y="330286"/>
                  </a:lnTo>
                  <a:lnTo>
                    <a:pt x="629832" y="369605"/>
                  </a:lnTo>
                  <a:lnTo>
                    <a:pt x="682318" y="377691"/>
                  </a:lnTo>
                  <a:lnTo>
                    <a:pt x="734804" y="411640"/>
                  </a:lnTo>
                  <a:lnTo>
                    <a:pt x="787290" y="448913"/>
                  </a:lnTo>
                  <a:lnTo>
                    <a:pt x="839776" y="447451"/>
                  </a:lnTo>
                  <a:lnTo>
                    <a:pt x="892262" y="466257"/>
                  </a:lnTo>
                  <a:lnTo>
                    <a:pt x="944748" y="496264"/>
                  </a:lnTo>
                  <a:lnTo>
                    <a:pt x="997234" y="525324"/>
                  </a:lnTo>
                  <a:lnTo>
                    <a:pt x="1049720" y="569897"/>
                  </a:lnTo>
                  <a:lnTo>
                    <a:pt x="1102206" y="568857"/>
                  </a:lnTo>
                  <a:lnTo>
                    <a:pt x="1154692" y="594229"/>
                  </a:lnTo>
                  <a:lnTo>
                    <a:pt x="1207178" y="589145"/>
                  </a:lnTo>
                  <a:lnTo>
                    <a:pt x="1259664" y="648281"/>
                  </a:lnTo>
                  <a:lnTo>
                    <a:pt x="1312150" y="661028"/>
                  </a:lnTo>
                  <a:lnTo>
                    <a:pt x="1364636" y="697098"/>
                  </a:lnTo>
                  <a:lnTo>
                    <a:pt x="1417122" y="716760"/>
                  </a:lnTo>
                  <a:lnTo>
                    <a:pt x="1469608" y="687762"/>
                  </a:lnTo>
                  <a:lnTo>
                    <a:pt x="1522094" y="762871"/>
                  </a:lnTo>
                  <a:lnTo>
                    <a:pt x="1574580" y="769986"/>
                  </a:lnTo>
                  <a:lnTo>
                    <a:pt x="1627066" y="776807"/>
                  </a:lnTo>
                  <a:lnTo>
                    <a:pt x="1679552" y="815793"/>
                  </a:lnTo>
                  <a:lnTo>
                    <a:pt x="1732038" y="810800"/>
                  </a:lnTo>
                  <a:lnTo>
                    <a:pt x="1784524" y="831067"/>
                  </a:lnTo>
                  <a:lnTo>
                    <a:pt x="1837010" y="872357"/>
                  </a:lnTo>
                  <a:lnTo>
                    <a:pt x="1889496" y="890159"/>
                  </a:lnTo>
                  <a:lnTo>
                    <a:pt x="1941982" y="918816"/>
                  </a:lnTo>
                  <a:lnTo>
                    <a:pt x="1994468" y="988420"/>
                  </a:lnTo>
                  <a:lnTo>
                    <a:pt x="2046954" y="1006303"/>
                  </a:lnTo>
                  <a:lnTo>
                    <a:pt x="2099440" y="1048833"/>
                  </a:lnTo>
                  <a:lnTo>
                    <a:pt x="2151926" y="1105159"/>
                  </a:lnTo>
                  <a:lnTo>
                    <a:pt x="2204412" y="1147735"/>
                  </a:lnTo>
                  <a:lnTo>
                    <a:pt x="2256898" y="1097404"/>
                  </a:lnTo>
                  <a:lnTo>
                    <a:pt x="2309384" y="1103326"/>
                  </a:lnTo>
                  <a:lnTo>
                    <a:pt x="2361870" y="1141821"/>
                  </a:lnTo>
                </a:path>
              </a:pathLst>
            </a:custGeom>
            <a:ln w="21681" cap="flat">
              <a:solidFill>
                <a:srgbClr val="00B0F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l158"/>
            <p:cNvSpPr/>
            <p:nvPr/>
          </p:nvSpPr>
          <p:spPr>
            <a:xfrm>
              <a:off x="693695" y="4569168"/>
              <a:ext cx="2361870" cy="1228651"/>
            </a:xfrm>
            <a:custGeom>
              <a:avLst/>
              <a:pathLst>
                <a:path w="2361870" h="1228651">
                  <a:moveTo>
                    <a:pt x="0" y="0"/>
                  </a:moveTo>
                  <a:lnTo>
                    <a:pt x="52486" y="129968"/>
                  </a:lnTo>
                  <a:lnTo>
                    <a:pt x="104972" y="308145"/>
                  </a:lnTo>
                  <a:lnTo>
                    <a:pt x="157458" y="419542"/>
                  </a:lnTo>
                  <a:lnTo>
                    <a:pt x="209944" y="520696"/>
                  </a:lnTo>
                  <a:lnTo>
                    <a:pt x="262430" y="585237"/>
                  </a:lnTo>
                  <a:lnTo>
                    <a:pt x="314916" y="700536"/>
                  </a:lnTo>
                  <a:lnTo>
                    <a:pt x="367402" y="747216"/>
                  </a:lnTo>
                  <a:lnTo>
                    <a:pt x="419888" y="762541"/>
                  </a:lnTo>
                  <a:lnTo>
                    <a:pt x="472374" y="780141"/>
                  </a:lnTo>
                  <a:lnTo>
                    <a:pt x="524860" y="794856"/>
                  </a:lnTo>
                  <a:lnTo>
                    <a:pt x="577346" y="809136"/>
                  </a:lnTo>
                  <a:lnTo>
                    <a:pt x="629832" y="826344"/>
                  </a:lnTo>
                  <a:lnTo>
                    <a:pt x="682318" y="836326"/>
                  </a:lnTo>
                  <a:lnTo>
                    <a:pt x="734804" y="836574"/>
                  </a:lnTo>
                  <a:lnTo>
                    <a:pt x="787290" y="836829"/>
                  </a:lnTo>
                  <a:lnTo>
                    <a:pt x="839776" y="870085"/>
                  </a:lnTo>
                  <a:lnTo>
                    <a:pt x="892262" y="903349"/>
                  </a:lnTo>
                  <a:lnTo>
                    <a:pt x="944748" y="964687"/>
                  </a:lnTo>
                  <a:lnTo>
                    <a:pt x="997234" y="981184"/>
                  </a:lnTo>
                  <a:lnTo>
                    <a:pt x="1049720" y="997682"/>
                  </a:lnTo>
                  <a:lnTo>
                    <a:pt x="1102206" y="1063673"/>
                  </a:lnTo>
                  <a:lnTo>
                    <a:pt x="1154692" y="1096669"/>
                  </a:lnTo>
                  <a:lnTo>
                    <a:pt x="1207178" y="1096669"/>
                  </a:lnTo>
                  <a:lnTo>
                    <a:pt x="1259664" y="1096669"/>
                  </a:lnTo>
                  <a:lnTo>
                    <a:pt x="1312150" y="1113167"/>
                  </a:lnTo>
                  <a:lnTo>
                    <a:pt x="1364636" y="1129664"/>
                  </a:lnTo>
                  <a:lnTo>
                    <a:pt x="1417122" y="1162660"/>
                  </a:lnTo>
                  <a:lnTo>
                    <a:pt x="1469608" y="1162660"/>
                  </a:lnTo>
                  <a:lnTo>
                    <a:pt x="1522094" y="1179158"/>
                  </a:lnTo>
                  <a:lnTo>
                    <a:pt x="1574580" y="1195656"/>
                  </a:lnTo>
                  <a:lnTo>
                    <a:pt x="1627066" y="1195656"/>
                  </a:lnTo>
                  <a:lnTo>
                    <a:pt x="1679552" y="1195656"/>
                  </a:lnTo>
                  <a:lnTo>
                    <a:pt x="1732038" y="1212153"/>
                  </a:lnTo>
                  <a:lnTo>
                    <a:pt x="1784524" y="1228651"/>
                  </a:lnTo>
                  <a:lnTo>
                    <a:pt x="1837010" y="1228651"/>
                  </a:lnTo>
                  <a:lnTo>
                    <a:pt x="1889496" y="1228651"/>
                  </a:lnTo>
                  <a:lnTo>
                    <a:pt x="1941982" y="1228651"/>
                  </a:lnTo>
                  <a:lnTo>
                    <a:pt x="1994468" y="1228651"/>
                  </a:lnTo>
                  <a:lnTo>
                    <a:pt x="2046954" y="1228651"/>
                  </a:lnTo>
                  <a:lnTo>
                    <a:pt x="2099440" y="1228651"/>
                  </a:lnTo>
                  <a:lnTo>
                    <a:pt x="2151926" y="1228651"/>
                  </a:lnTo>
                  <a:lnTo>
                    <a:pt x="2204412" y="1228651"/>
                  </a:lnTo>
                  <a:lnTo>
                    <a:pt x="2256898" y="1228651"/>
                  </a:lnTo>
                  <a:lnTo>
                    <a:pt x="2309384" y="1228651"/>
                  </a:lnTo>
                  <a:lnTo>
                    <a:pt x="2361870" y="1228651"/>
                  </a:lnTo>
                </a:path>
              </a:pathLst>
            </a:custGeom>
            <a:ln w="21681" cap="flat">
              <a:solidFill>
                <a:srgbClr val="E76BF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l159"/>
            <p:cNvSpPr/>
            <p:nvPr/>
          </p:nvSpPr>
          <p:spPr>
            <a:xfrm>
              <a:off x="693695" y="3870183"/>
              <a:ext cx="2361870" cy="2422571"/>
            </a:xfrm>
            <a:custGeom>
              <a:avLst/>
              <a:pathLst>
                <a:path w="2361870" h="2422571">
                  <a:moveTo>
                    <a:pt x="0" y="0"/>
                  </a:moveTo>
                  <a:lnTo>
                    <a:pt x="52486" y="28635"/>
                  </a:lnTo>
                  <a:lnTo>
                    <a:pt x="104972" y="57887"/>
                  </a:lnTo>
                  <a:lnTo>
                    <a:pt x="157458" y="87774"/>
                  </a:lnTo>
                  <a:lnTo>
                    <a:pt x="209944" y="118318"/>
                  </a:lnTo>
                  <a:lnTo>
                    <a:pt x="262430" y="149541"/>
                  </a:lnTo>
                  <a:lnTo>
                    <a:pt x="314916" y="181466"/>
                  </a:lnTo>
                  <a:lnTo>
                    <a:pt x="367402" y="214116"/>
                  </a:lnTo>
                  <a:lnTo>
                    <a:pt x="419888" y="247516"/>
                  </a:lnTo>
                  <a:lnTo>
                    <a:pt x="472374" y="281694"/>
                  </a:lnTo>
                  <a:lnTo>
                    <a:pt x="524860" y="316675"/>
                  </a:lnTo>
                  <a:lnTo>
                    <a:pt x="577346" y="352490"/>
                  </a:lnTo>
                  <a:lnTo>
                    <a:pt x="629832" y="389168"/>
                  </a:lnTo>
                  <a:lnTo>
                    <a:pt x="682318" y="426740"/>
                  </a:lnTo>
                  <a:lnTo>
                    <a:pt x="734804" y="465240"/>
                  </a:lnTo>
                  <a:lnTo>
                    <a:pt x="787290" y="504702"/>
                  </a:lnTo>
                  <a:lnTo>
                    <a:pt x="839776" y="545163"/>
                  </a:lnTo>
                  <a:lnTo>
                    <a:pt x="892262" y="586662"/>
                  </a:lnTo>
                  <a:lnTo>
                    <a:pt x="944748" y="629239"/>
                  </a:lnTo>
                  <a:lnTo>
                    <a:pt x="997234" y="672936"/>
                  </a:lnTo>
                  <a:lnTo>
                    <a:pt x="1049720" y="717798"/>
                  </a:lnTo>
                  <a:lnTo>
                    <a:pt x="1102206" y="763873"/>
                  </a:lnTo>
                  <a:lnTo>
                    <a:pt x="1154692" y="811211"/>
                  </a:lnTo>
                  <a:lnTo>
                    <a:pt x="1207178" y="859863"/>
                  </a:lnTo>
                  <a:lnTo>
                    <a:pt x="1259664" y="909885"/>
                  </a:lnTo>
                  <a:lnTo>
                    <a:pt x="1312150" y="961337"/>
                  </a:lnTo>
                  <a:lnTo>
                    <a:pt x="1364636" y="1014281"/>
                  </a:lnTo>
                  <a:lnTo>
                    <a:pt x="1417122" y="1068781"/>
                  </a:lnTo>
                  <a:lnTo>
                    <a:pt x="1469608" y="1124908"/>
                  </a:lnTo>
                  <a:lnTo>
                    <a:pt x="1522094" y="1182736"/>
                  </a:lnTo>
                  <a:lnTo>
                    <a:pt x="1574580" y="1242344"/>
                  </a:lnTo>
                  <a:lnTo>
                    <a:pt x="1627066" y="1303814"/>
                  </a:lnTo>
                  <a:lnTo>
                    <a:pt x="1679552" y="1367236"/>
                  </a:lnTo>
                  <a:lnTo>
                    <a:pt x="1732038" y="1432703"/>
                  </a:lnTo>
                  <a:lnTo>
                    <a:pt x="1784524" y="1500317"/>
                  </a:lnTo>
                  <a:lnTo>
                    <a:pt x="1837010" y="1570185"/>
                  </a:lnTo>
                  <a:lnTo>
                    <a:pt x="1889496" y="1642421"/>
                  </a:lnTo>
                  <a:lnTo>
                    <a:pt x="1941982" y="1717148"/>
                  </a:lnTo>
                  <a:lnTo>
                    <a:pt x="1994468" y="1794497"/>
                  </a:lnTo>
                  <a:lnTo>
                    <a:pt x="2046954" y="1874608"/>
                  </a:lnTo>
                  <a:lnTo>
                    <a:pt x="2099440" y="1957633"/>
                  </a:lnTo>
                  <a:lnTo>
                    <a:pt x="2151926" y="2043733"/>
                  </a:lnTo>
                  <a:lnTo>
                    <a:pt x="2204412" y="2133081"/>
                  </a:lnTo>
                  <a:lnTo>
                    <a:pt x="2256898" y="2225866"/>
                  </a:lnTo>
                  <a:lnTo>
                    <a:pt x="2309384" y="2322290"/>
                  </a:lnTo>
                  <a:lnTo>
                    <a:pt x="2361870" y="2422571"/>
                  </a:lnTo>
                </a:path>
              </a:pathLst>
            </a:custGeom>
            <a:ln w="21681" cap="flat">
              <a:solidFill>
                <a:srgbClr val="00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/>
          </p:txBody>
        </p:sp>
        <p:sp>
          <p:nvSpPr>
            <p:cNvPr id="160" name="pl160"/>
            <p:cNvSpPr/>
            <p:nvPr/>
          </p:nvSpPr>
          <p:spPr>
            <a:xfrm>
              <a:off x="693695" y="5797820"/>
              <a:ext cx="2361870" cy="0"/>
            </a:xfrm>
            <a:custGeom>
              <a:avLst/>
              <a:pathLst>
                <a:path w="2361870" h="0">
                  <a:moveTo>
                    <a:pt x="0" y="0"/>
                  </a:moveTo>
                  <a:lnTo>
                    <a:pt x="52486" y="0"/>
                  </a:lnTo>
                  <a:lnTo>
                    <a:pt x="104972" y="0"/>
                  </a:lnTo>
                  <a:lnTo>
                    <a:pt x="157458" y="0"/>
                  </a:lnTo>
                  <a:lnTo>
                    <a:pt x="209944" y="0"/>
                  </a:lnTo>
                  <a:lnTo>
                    <a:pt x="262430" y="0"/>
                  </a:lnTo>
                  <a:lnTo>
                    <a:pt x="314916" y="0"/>
                  </a:lnTo>
                  <a:lnTo>
                    <a:pt x="367402" y="0"/>
                  </a:lnTo>
                  <a:lnTo>
                    <a:pt x="419888" y="0"/>
                  </a:lnTo>
                  <a:lnTo>
                    <a:pt x="472374" y="0"/>
                  </a:lnTo>
                  <a:lnTo>
                    <a:pt x="524860" y="0"/>
                  </a:lnTo>
                  <a:lnTo>
                    <a:pt x="577346" y="0"/>
                  </a:lnTo>
                  <a:lnTo>
                    <a:pt x="629832" y="0"/>
                  </a:lnTo>
                  <a:lnTo>
                    <a:pt x="682318" y="0"/>
                  </a:lnTo>
                  <a:lnTo>
                    <a:pt x="734804" y="0"/>
                  </a:lnTo>
                  <a:lnTo>
                    <a:pt x="787290" y="0"/>
                  </a:lnTo>
                  <a:lnTo>
                    <a:pt x="839776" y="0"/>
                  </a:lnTo>
                  <a:lnTo>
                    <a:pt x="892262" y="0"/>
                  </a:lnTo>
                  <a:lnTo>
                    <a:pt x="944748" y="0"/>
                  </a:lnTo>
                  <a:lnTo>
                    <a:pt x="997234" y="0"/>
                  </a:lnTo>
                  <a:lnTo>
                    <a:pt x="1049720" y="0"/>
                  </a:lnTo>
                  <a:lnTo>
                    <a:pt x="1102206" y="0"/>
                  </a:lnTo>
                  <a:lnTo>
                    <a:pt x="1154692" y="0"/>
                  </a:lnTo>
                  <a:lnTo>
                    <a:pt x="1207178" y="0"/>
                  </a:lnTo>
                  <a:lnTo>
                    <a:pt x="1259664" y="0"/>
                  </a:lnTo>
                  <a:lnTo>
                    <a:pt x="1312150" y="0"/>
                  </a:lnTo>
                  <a:lnTo>
                    <a:pt x="1364636" y="0"/>
                  </a:lnTo>
                  <a:lnTo>
                    <a:pt x="1417122" y="0"/>
                  </a:lnTo>
                  <a:lnTo>
                    <a:pt x="1469608" y="0"/>
                  </a:lnTo>
                  <a:lnTo>
                    <a:pt x="1522094" y="0"/>
                  </a:lnTo>
                  <a:lnTo>
                    <a:pt x="1574580" y="0"/>
                  </a:lnTo>
                  <a:lnTo>
                    <a:pt x="1627066" y="0"/>
                  </a:lnTo>
                  <a:lnTo>
                    <a:pt x="1679552" y="0"/>
                  </a:lnTo>
                  <a:lnTo>
                    <a:pt x="1732038" y="0"/>
                  </a:lnTo>
                  <a:lnTo>
                    <a:pt x="1784524" y="0"/>
                  </a:lnTo>
                  <a:lnTo>
                    <a:pt x="1837010" y="0"/>
                  </a:lnTo>
                  <a:lnTo>
                    <a:pt x="1889496" y="0"/>
                  </a:lnTo>
                  <a:lnTo>
                    <a:pt x="1941982" y="0"/>
                  </a:lnTo>
                  <a:lnTo>
                    <a:pt x="1994468" y="0"/>
                  </a:lnTo>
                  <a:lnTo>
                    <a:pt x="2046954" y="0"/>
                  </a:lnTo>
                  <a:lnTo>
                    <a:pt x="2099440" y="0"/>
                  </a:lnTo>
                  <a:lnTo>
                    <a:pt x="2151926" y="0"/>
                  </a:lnTo>
                  <a:lnTo>
                    <a:pt x="2204412" y="0"/>
                  </a:lnTo>
                  <a:lnTo>
                    <a:pt x="2256898" y="0"/>
                  </a:lnTo>
                  <a:lnTo>
                    <a:pt x="2309384" y="0"/>
                  </a:lnTo>
                  <a:lnTo>
                    <a:pt x="2361870" y="0"/>
                  </a:lnTo>
                </a:path>
              </a:pathLst>
            </a:custGeom>
            <a:ln w="21681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161" name="tx161"/>
            <p:cNvSpPr/>
            <p:nvPr/>
          </p:nvSpPr>
          <p:spPr>
            <a:xfrm>
              <a:off x="136804" y="3756283"/>
              <a:ext cx="351038" cy="18105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991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(C)</a:t>
              </a:r>
            </a:p>
          </p:txBody>
        </p:sp>
        <p:sp>
          <p:nvSpPr>
            <p:cNvPr id="162" name="rc162"/>
            <p:cNvSpPr/>
            <p:nvPr/>
          </p:nvSpPr>
          <p:spPr>
            <a:xfrm>
              <a:off x="575602" y="3747231"/>
              <a:ext cx="2598057" cy="2666738"/>
            </a:xfrm>
            <a:prstGeom prst="rect">
              <a:avLst/>
            </a:prstGeom>
            <a:noFill/>
            <a:ln w="14782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tx163"/>
            <p:cNvSpPr/>
            <p:nvPr/>
          </p:nvSpPr>
          <p:spPr>
            <a:xfrm>
              <a:off x="297332" y="6216142"/>
              <a:ext cx="2099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1</a:t>
              </a:r>
            </a:p>
          </p:txBody>
        </p:sp>
        <p:sp>
          <p:nvSpPr>
            <p:cNvPr id="164" name="tx164"/>
            <p:cNvSpPr/>
            <p:nvPr/>
          </p:nvSpPr>
          <p:spPr>
            <a:xfrm>
              <a:off x="337931" y="5754203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</a:t>
              </a:r>
            </a:p>
          </p:txBody>
        </p:sp>
        <p:sp>
          <p:nvSpPr>
            <p:cNvPr id="165" name="tx165"/>
            <p:cNvSpPr/>
            <p:nvPr/>
          </p:nvSpPr>
          <p:spPr>
            <a:xfrm>
              <a:off x="337931" y="5292265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1</a:t>
              </a:r>
            </a:p>
          </p:txBody>
        </p:sp>
        <p:sp>
          <p:nvSpPr>
            <p:cNvPr id="166" name="tx166"/>
            <p:cNvSpPr/>
            <p:nvPr/>
          </p:nvSpPr>
          <p:spPr>
            <a:xfrm>
              <a:off x="337931" y="4830326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</a:t>
              </a:r>
            </a:p>
          </p:txBody>
        </p:sp>
        <p:sp>
          <p:nvSpPr>
            <p:cNvPr id="167" name="tx167"/>
            <p:cNvSpPr/>
            <p:nvPr/>
          </p:nvSpPr>
          <p:spPr>
            <a:xfrm>
              <a:off x="337931" y="4368388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3</a:t>
              </a:r>
            </a:p>
          </p:txBody>
        </p:sp>
        <p:sp>
          <p:nvSpPr>
            <p:cNvPr id="168" name="tx168"/>
            <p:cNvSpPr/>
            <p:nvPr/>
          </p:nvSpPr>
          <p:spPr>
            <a:xfrm>
              <a:off x="337931" y="3906450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4</a:t>
              </a:r>
            </a:p>
          </p:txBody>
        </p:sp>
        <p:sp>
          <p:nvSpPr>
            <p:cNvPr id="169" name="pl169"/>
            <p:cNvSpPr/>
            <p:nvPr/>
          </p:nvSpPr>
          <p:spPr>
            <a:xfrm>
              <a:off x="537644" y="6259758"/>
              <a:ext cx="37957" cy="0"/>
            </a:xfrm>
            <a:custGeom>
              <a:avLst/>
              <a:pathLst>
                <a:path w="37957" h="0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l170"/>
            <p:cNvSpPr/>
            <p:nvPr/>
          </p:nvSpPr>
          <p:spPr>
            <a:xfrm>
              <a:off x="537644" y="5797820"/>
              <a:ext cx="37957" cy="0"/>
            </a:xfrm>
            <a:custGeom>
              <a:avLst/>
              <a:pathLst>
                <a:path w="37957" h="0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l171"/>
            <p:cNvSpPr/>
            <p:nvPr/>
          </p:nvSpPr>
          <p:spPr>
            <a:xfrm>
              <a:off x="537644" y="5335882"/>
              <a:ext cx="37957" cy="0"/>
            </a:xfrm>
            <a:custGeom>
              <a:avLst/>
              <a:pathLst>
                <a:path w="37957" h="0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l172"/>
            <p:cNvSpPr/>
            <p:nvPr/>
          </p:nvSpPr>
          <p:spPr>
            <a:xfrm>
              <a:off x="537644" y="4873943"/>
              <a:ext cx="37957" cy="0"/>
            </a:xfrm>
            <a:custGeom>
              <a:avLst/>
              <a:pathLst>
                <a:path w="37957" h="0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l173"/>
            <p:cNvSpPr/>
            <p:nvPr/>
          </p:nvSpPr>
          <p:spPr>
            <a:xfrm>
              <a:off x="537644" y="4412005"/>
              <a:ext cx="37957" cy="0"/>
            </a:xfrm>
            <a:custGeom>
              <a:avLst/>
              <a:pathLst>
                <a:path w="37957" h="0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l174"/>
            <p:cNvSpPr/>
            <p:nvPr/>
          </p:nvSpPr>
          <p:spPr>
            <a:xfrm>
              <a:off x="537644" y="3950067"/>
              <a:ext cx="37957" cy="0"/>
            </a:xfrm>
            <a:custGeom>
              <a:avLst/>
              <a:pathLst>
                <a:path w="37957" h="0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l175"/>
            <p:cNvSpPr/>
            <p:nvPr/>
          </p:nvSpPr>
          <p:spPr>
            <a:xfrm>
              <a:off x="956125" y="6413969"/>
              <a:ext cx="0" cy="37957"/>
            </a:xfrm>
            <a:custGeom>
              <a:avLst/>
              <a:pathLst>
                <a:path w="0"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l176"/>
            <p:cNvSpPr/>
            <p:nvPr/>
          </p:nvSpPr>
          <p:spPr>
            <a:xfrm>
              <a:off x="1480985" y="6413969"/>
              <a:ext cx="0" cy="37957"/>
            </a:xfrm>
            <a:custGeom>
              <a:avLst/>
              <a:pathLst>
                <a:path w="0"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l177"/>
            <p:cNvSpPr/>
            <p:nvPr/>
          </p:nvSpPr>
          <p:spPr>
            <a:xfrm>
              <a:off x="2005846" y="6413969"/>
              <a:ext cx="0" cy="37957"/>
            </a:xfrm>
            <a:custGeom>
              <a:avLst/>
              <a:pathLst>
                <a:path w="0"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l178"/>
            <p:cNvSpPr/>
            <p:nvPr/>
          </p:nvSpPr>
          <p:spPr>
            <a:xfrm>
              <a:off x="2530706" y="6413969"/>
              <a:ext cx="0" cy="37957"/>
            </a:xfrm>
            <a:custGeom>
              <a:avLst/>
              <a:pathLst>
                <a:path w="0"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l179"/>
            <p:cNvSpPr/>
            <p:nvPr/>
          </p:nvSpPr>
          <p:spPr>
            <a:xfrm>
              <a:off x="3055566" y="6413969"/>
              <a:ext cx="0" cy="37957"/>
            </a:xfrm>
            <a:custGeom>
              <a:avLst/>
              <a:pathLst>
                <a:path w="0"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tx180"/>
            <p:cNvSpPr/>
            <p:nvPr/>
          </p:nvSpPr>
          <p:spPr>
            <a:xfrm>
              <a:off x="871452" y="6482293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1</a:t>
              </a:r>
            </a:p>
          </p:txBody>
        </p:sp>
        <p:sp>
          <p:nvSpPr>
            <p:cNvPr id="181" name="tx181"/>
            <p:cNvSpPr/>
            <p:nvPr/>
          </p:nvSpPr>
          <p:spPr>
            <a:xfrm>
              <a:off x="1396312" y="6482293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</a:t>
              </a:r>
            </a:p>
          </p:txBody>
        </p:sp>
        <p:sp>
          <p:nvSpPr>
            <p:cNvPr id="182" name="tx182"/>
            <p:cNvSpPr/>
            <p:nvPr/>
          </p:nvSpPr>
          <p:spPr>
            <a:xfrm>
              <a:off x="1921172" y="6482293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3</a:t>
              </a:r>
            </a:p>
          </p:txBody>
        </p:sp>
        <p:sp>
          <p:nvSpPr>
            <p:cNvPr id="183" name="tx183"/>
            <p:cNvSpPr/>
            <p:nvPr/>
          </p:nvSpPr>
          <p:spPr>
            <a:xfrm>
              <a:off x="2446032" y="6482293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4</a:t>
              </a:r>
            </a:p>
          </p:txBody>
        </p:sp>
        <p:sp>
          <p:nvSpPr>
            <p:cNvPr id="184" name="tx184"/>
            <p:cNvSpPr/>
            <p:nvPr/>
          </p:nvSpPr>
          <p:spPr>
            <a:xfrm>
              <a:off x="2970893" y="6482293"/>
              <a:ext cx="169346" cy="8723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60" i="0" b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</a:t>
              </a:r>
            </a:p>
          </p:txBody>
        </p:sp>
        <p:sp>
          <p:nvSpPr>
            <p:cNvPr id="185" name="tx185"/>
            <p:cNvSpPr/>
            <p:nvPr/>
          </p:nvSpPr>
          <p:spPr>
            <a:xfrm>
              <a:off x="1167251" y="6639377"/>
              <a:ext cx="1414759" cy="10917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2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hreshold probability</a:t>
              </a:r>
            </a:p>
          </p:txBody>
        </p:sp>
        <p:sp>
          <p:nvSpPr>
            <p:cNvPr id="186" name="tx186"/>
            <p:cNvSpPr/>
            <p:nvPr/>
          </p:nvSpPr>
          <p:spPr>
            <a:xfrm rot="-5400000">
              <a:off x="-238043" y="5026010"/>
              <a:ext cx="737097" cy="10917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2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et benefit</a:t>
              </a:r>
            </a:p>
          </p:txBody>
        </p:sp>
        <p:sp>
          <p:nvSpPr>
            <p:cNvPr id="187" name="rc187"/>
            <p:cNvSpPr/>
            <p:nvPr/>
          </p:nvSpPr>
          <p:spPr>
            <a:xfrm>
              <a:off x="3325490" y="4346611"/>
              <a:ext cx="1170593" cy="1467977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88" name="tx188"/>
            <p:cNvSpPr/>
            <p:nvPr/>
          </p:nvSpPr>
          <p:spPr>
            <a:xfrm>
              <a:off x="3401406" y="4439413"/>
              <a:ext cx="415137" cy="10917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2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odel</a:t>
              </a:r>
            </a:p>
          </p:txBody>
        </p:sp>
        <p:sp>
          <p:nvSpPr>
            <p:cNvPr id="189" name="rc189"/>
            <p:cNvSpPr/>
            <p:nvPr/>
          </p:nvSpPr>
          <p:spPr>
            <a:xfrm>
              <a:off x="3401406" y="4641393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90" name="pl190"/>
            <p:cNvSpPr/>
            <p:nvPr/>
          </p:nvSpPr>
          <p:spPr>
            <a:xfrm>
              <a:off x="3423351" y="4751121"/>
              <a:ext cx="175564" cy="0"/>
            </a:xfrm>
            <a:custGeom>
              <a:avLst/>
              <a:pathLst>
                <a:path w="175564" h="0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21681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rc191"/>
            <p:cNvSpPr/>
            <p:nvPr/>
          </p:nvSpPr>
          <p:spPr>
            <a:xfrm>
              <a:off x="3401406" y="4860849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92" name="pl192"/>
            <p:cNvSpPr/>
            <p:nvPr/>
          </p:nvSpPr>
          <p:spPr>
            <a:xfrm>
              <a:off x="3423351" y="4970577"/>
              <a:ext cx="175564" cy="0"/>
            </a:xfrm>
            <a:custGeom>
              <a:avLst/>
              <a:pathLst>
                <a:path w="175564" h="0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21681" cap="flat">
              <a:solidFill>
                <a:srgbClr val="A3A5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rc193"/>
            <p:cNvSpPr/>
            <p:nvPr/>
          </p:nvSpPr>
          <p:spPr>
            <a:xfrm>
              <a:off x="3401406" y="5080305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94" name="pl194"/>
            <p:cNvSpPr/>
            <p:nvPr/>
          </p:nvSpPr>
          <p:spPr>
            <a:xfrm>
              <a:off x="3423351" y="5190033"/>
              <a:ext cx="175564" cy="0"/>
            </a:xfrm>
            <a:custGeom>
              <a:avLst/>
              <a:pathLst>
                <a:path w="175564" h="0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21681" cap="flat">
              <a:solidFill>
                <a:srgbClr val="00BF7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" name="rc195"/>
            <p:cNvSpPr/>
            <p:nvPr/>
          </p:nvSpPr>
          <p:spPr>
            <a:xfrm>
              <a:off x="3401406" y="5299761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96" name="pl196"/>
            <p:cNvSpPr/>
            <p:nvPr/>
          </p:nvSpPr>
          <p:spPr>
            <a:xfrm>
              <a:off x="3423351" y="5409489"/>
              <a:ext cx="175564" cy="0"/>
            </a:xfrm>
            <a:custGeom>
              <a:avLst/>
              <a:pathLst>
                <a:path w="175564" h="0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21681" cap="flat">
              <a:solidFill>
                <a:srgbClr val="00B0F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" name="rc197"/>
            <p:cNvSpPr/>
            <p:nvPr/>
          </p:nvSpPr>
          <p:spPr>
            <a:xfrm>
              <a:off x="3401406" y="5519217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98" name="pl198"/>
            <p:cNvSpPr/>
            <p:nvPr/>
          </p:nvSpPr>
          <p:spPr>
            <a:xfrm>
              <a:off x="3423351" y="5628945"/>
              <a:ext cx="175564" cy="0"/>
            </a:xfrm>
            <a:custGeom>
              <a:avLst/>
              <a:pathLst>
                <a:path w="175564" h="0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21681" cap="flat">
              <a:solidFill>
                <a:srgbClr val="E76BF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" name="tx199"/>
            <p:cNvSpPr/>
            <p:nvPr/>
          </p:nvSpPr>
          <p:spPr>
            <a:xfrm>
              <a:off x="3696777" y="4705630"/>
              <a:ext cx="183520" cy="9098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FLI</a:t>
              </a:r>
            </a:p>
          </p:txBody>
        </p:sp>
        <p:sp>
          <p:nvSpPr>
            <p:cNvPr id="200" name="tx200"/>
            <p:cNvSpPr/>
            <p:nvPr/>
          </p:nvSpPr>
          <p:spPr>
            <a:xfrm>
              <a:off x="3696777" y="4925086"/>
              <a:ext cx="211683" cy="9098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HSI</a:t>
              </a:r>
            </a:p>
          </p:txBody>
        </p:sp>
        <p:sp>
          <p:nvSpPr>
            <p:cNvPr id="201" name="tx201"/>
            <p:cNvSpPr/>
            <p:nvPr/>
          </p:nvSpPr>
          <p:spPr>
            <a:xfrm>
              <a:off x="3696777" y="5144542"/>
              <a:ext cx="691560" cy="9098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AFLD-LFS</a:t>
              </a:r>
            </a:p>
          </p:txBody>
        </p:sp>
        <p:sp>
          <p:nvSpPr>
            <p:cNvPr id="202" name="tx202"/>
            <p:cNvSpPr/>
            <p:nvPr/>
          </p:nvSpPr>
          <p:spPr>
            <a:xfrm>
              <a:off x="3696777" y="5363998"/>
              <a:ext cx="480151" cy="9098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LDLD1</a:t>
              </a:r>
            </a:p>
          </p:txBody>
        </p:sp>
        <p:sp>
          <p:nvSpPr>
            <p:cNvPr id="203" name="tx203"/>
            <p:cNvSpPr/>
            <p:nvPr/>
          </p:nvSpPr>
          <p:spPr>
            <a:xfrm>
              <a:off x="3696777" y="5583454"/>
              <a:ext cx="402244" cy="9098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US-FLI</a:t>
              </a:r>
            </a:p>
          </p:txBody>
        </p:sp>
        <p:sp>
          <p:nvSpPr>
            <p:cNvPr id="204" name="tx204"/>
            <p:cNvSpPr/>
            <p:nvPr/>
          </p:nvSpPr>
          <p:spPr>
            <a:xfrm>
              <a:off x="575602" y="3504915"/>
              <a:ext cx="3888028" cy="12728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4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Decision Curve Analysis: Women aged ≥55 years</a:t>
              </a:r>
            </a:p>
          </p:txBody>
        </p:sp>
        <p:sp>
          <p:nvSpPr>
            <p:cNvPr id="205" name="rc205"/>
            <p:cNvSpPr/>
            <p:nvPr/>
          </p:nvSpPr>
          <p:spPr>
            <a:xfrm>
              <a:off x="4571999" y="3429000"/>
              <a:ext cx="4572000" cy="3429000"/>
            </a:xfrm>
            <a:prstGeom prst="rect">
              <a:avLst/>
            </a:prstGeom>
            <a:noFill/>
          </p:spPr>
          <p:txBody>
            <a:bodyPr/>
            <a:lstStyle/>
            <a:p/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6-06-09T22:02:04Z</dcterms:modified>
  <cp:category/>
</cp:coreProperties>
</file>